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67" r:id="rId3"/>
    <p:sldId id="269" r:id="rId4"/>
    <p:sldId id="266" r:id="rId5"/>
  </p:sldIdLst>
  <p:sldSz cx="12192000" cy="6858000"/>
  <p:notesSz cx="6858000" cy="9144000"/>
  <p:defaultTextStyle>
    <a:defPPr>
      <a:defRPr lang="en-150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1" autoAdjust="0"/>
    <p:restoredTop sz="94660"/>
  </p:normalViewPr>
  <p:slideViewPr>
    <p:cSldViewPr snapToGrid="0">
      <p:cViewPr>
        <p:scale>
          <a:sx n="114" d="100"/>
          <a:sy n="114" d="100"/>
        </p:scale>
        <p:origin x="928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85604-C7CC-48CD-8CFA-FB24198CC3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FE4923-E698-4E61-8CC5-2C080D5D74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15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4E1E18-94E7-436E-AC85-308AB037D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35BF9-1D1C-491F-B038-BAE6BCB3E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108D9F-84E0-425A-B75C-E1AB86BAF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595304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B192CC-B816-4149-BA0E-5119E9DD3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7F4CA6-9525-4942-ABF1-71993051BB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22E92B-9073-42CB-AB05-E87C88128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8E6B79-2A05-4262-B6AE-510888079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7BEF0E-DBB7-4316-A546-CCC590319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272621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F4F2018-34E9-413F-BF44-4B3ED4FED2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70D939-2DCD-4703-8C3E-102912CC8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6D2F7C-9129-4F97-A16D-EDA099FF2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58A867-5F46-44B2-BD45-124A9062F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47D33E-DBD3-4F86-B601-F55C0FE40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063728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98772-9E33-419B-B2E6-B8BD8CF19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BB9549-A69D-4E15-A722-D00F11F377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DE8BE-7522-4258-9429-0D77DFEEE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CD6CF-96F1-44D6-8C46-463377326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5D95A9-8BB5-461E-8E30-B91FD4E55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4013912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572633-A313-49EA-8732-9D766A3956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F1A34B-6987-49DD-BA63-AD92351186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176CA8-785B-4BC9-BB33-6294419C5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F039B6-C54B-47C9-A793-D63358A66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D3E8E-4DFF-4025-AE18-530043252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46489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41CB2-3CAA-461F-B276-C94590648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F59332-A708-4649-9DCE-92EFEB10D6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D3671E-4E74-4D25-A764-A454B96FB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978A63-F36C-42F1-B4A6-9FCF61C0A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E1EB88-34E0-4763-BD84-3BADDB104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30C77E-139C-4709-90E5-914BB6AF1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514999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24312-5179-4AD8-87AB-48C6FF5C1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4AA958-83E7-478F-AF22-3BE8CF6C01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A012F0-E7F0-4CA1-A1FE-A4C770E59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8A80DD-8670-4E51-80F8-BFB299E96B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02615B-CFA5-4D95-8E43-DDDB2F822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6EB2FB-EC91-4403-B9BE-045739F7C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93FBA5-8EC2-4624-9FD8-AD8A0EC84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086152-51B5-4B4B-86A1-ACB550A69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1907078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595AB-718B-4CB3-934A-74BE142539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3B22AD-CA86-4C79-9B7C-1BC298315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BD4EAB-4EF8-4B0B-8D42-959C13942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B10DE3-24A3-4573-8038-7AFEBD0FA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4169273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DBA777-0CFB-4CB6-9415-99535C78C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8E3038-A275-41D1-AFDE-2EB1E94B7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920468-DB21-409C-A2EC-F0D3FD54A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776982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D6DA3-33A6-4D4B-87D0-B658A22F5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1EB9E3-1E74-48AF-8F4B-3720721FEE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BF29EB-4AB5-4EB2-80E0-D7589BC2FD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F85A2F-DF8C-474E-AC8C-22CAD44CF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3C24B6-078E-41D5-AAB7-BC6FAD5DA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F53D3D-1DB9-4491-A5BC-476B13E46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887414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C840D-8E2E-4072-93C2-06E79687F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05CBF5-FF51-4E41-98ED-1A01EE7CC5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15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A72870-13E4-42E9-9F16-2585C6153E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42B3ED-561A-4012-882B-663350C78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82822A-2A9C-475A-A79B-4E4E5DE41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15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EABE7E-D5AE-4C92-A703-14E09C347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211850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1431E5-51E4-4800-A023-B96C50E560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15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648E31-4F61-4217-958B-FE94A47632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15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762C2D-FABF-4C99-BB58-909403A780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84C0F-BD30-402B-A73D-3A49FBCCE8AB}" type="datetimeFigureOut">
              <a:rPr lang="en-150" smtClean="0"/>
              <a:t>12/13/21</a:t>
            </a:fld>
            <a:endParaRPr lang="en-15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C630A5-C3C1-4CF2-A807-C33604CE94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15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62CA39-3195-4400-863B-CA1FAF4522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570C6-F2EE-4E6D-9841-3A1F08B1DF9F}" type="slidenum">
              <a:rPr lang="en-150" smtClean="0"/>
              <a:t>‹N°›</a:t>
            </a:fld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1143886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150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6.svg"/><Relationship Id="rId5" Type="http://schemas.openxmlformats.org/officeDocument/2006/relationships/image" Target="../media/image10.png"/><Relationship Id="rId10" Type="http://schemas.openxmlformats.org/officeDocument/2006/relationships/image" Target="../media/image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10" Type="http://schemas.openxmlformats.org/officeDocument/2006/relationships/image" Target="../media/image6.svg"/><Relationship Id="rId4" Type="http://schemas.openxmlformats.org/officeDocument/2006/relationships/image" Target="../media/image17.png"/><Relationship Id="rId9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3.png"/><Relationship Id="rId7" Type="http://schemas.openxmlformats.org/officeDocument/2006/relationships/image" Target="../media/image25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11" Type="http://schemas.openxmlformats.org/officeDocument/2006/relationships/image" Target="../media/image6.svg"/><Relationship Id="rId5" Type="http://schemas.openxmlformats.org/officeDocument/2006/relationships/image" Target="../media/image2.png"/><Relationship Id="rId10" Type="http://schemas.openxmlformats.org/officeDocument/2006/relationships/image" Target="../media/image5.png"/><Relationship Id="rId4" Type="http://schemas.openxmlformats.org/officeDocument/2006/relationships/image" Target="../media/image1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967192C-48E8-44A1-BA44-08E38FD60D6C}"/>
              </a:ext>
            </a:extLst>
          </p:cNvPr>
          <p:cNvSpPr txBox="1"/>
          <p:nvPr/>
        </p:nvSpPr>
        <p:spPr>
          <a:xfrm>
            <a:off x="100390" y="80339"/>
            <a:ext cx="245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A-</a:t>
            </a:r>
            <a:r>
              <a:rPr lang="en-US" b="1" dirty="0" err="1"/>
              <a:t>mDGKk</a:t>
            </a:r>
            <a:r>
              <a:rPr lang="en-US" b="1" dirty="0"/>
              <a:t>:</a:t>
            </a:r>
            <a:endParaRPr lang="en-1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F99B025-43BF-4286-8DD1-81B3EDE8E5D8}"/>
              </a:ext>
            </a:extLst>
          </p:cNvPr>
          <p:cNvSpPr txBox="1"/>
          <p:nvPr/>
        </p:nvSpPr>
        <p:spPr>
          <a:xfrm>
            <a:off x="209724" y="1509900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1</a:t>
            </a:r>
            <a:endParaRPr lang="en-1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1856775-9C60-40B3-806C-D312A23F69F8}"/>
              </a:ext>
            </a:extLst>
          </p:cNvPr>
          <p:cNvSpPr txBox="1"/>
          <p:nvPr/>
        </p:nvSpPr>
        <p:spPr>
          <a:xfrm>
            <a:off x="1293554" y="1185897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BD45816-862D-4DFD-83FE-A14202A3E9D1}"/>
              </a:ext>
            </a:extLst>
          </p:cNvPr>
          <p:cNvSpPr txBox="1"/>
          <p:nvPr/>
        </p:nvSpPr>
        <p:spPr>
          <a:xfrm>
            <a:off x="4456304" y="1185896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F8D61BE-72EB-43D9-9612-55DFCD93935B}"/>
              </a:ext>
            </a:extLst>
          </p:cNvPr>
          <p:cNvCxnSpPr>
            <a:cxnSpLocks/>
          </p:cNvCxnSpPr>
          <p:nvPr/>
        </p:nvCxnSpPr>
        <p:spPr>
          <a:xfrm>
            <a:off x="1411889" y="1058587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C3049B5-3D3D-4412-B2DF-75D406114798}"/>
              </a:ext>
            </a:extLst>
          </p:cNvPr>
          <p:cNvSpPr txBox="1"/>
          <p:nvPr/>
        </p:nvSpPr>
        <p:spPr>
          <a:xfrm>
            <a:off x="1650349" y="770398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6571EF7B-E35E-4D0C-B031-B34799812603}"/>
              </a:ext>
            </a:extLst>
          </p:cNvPr>
          <p:cNvCxnSpPr>
            <a:cxnSpLocks/>
          </p:cNvCxnSpPr>
          <p:nvPr/>
        </p:nvCxnSpPr>
        <p:spPr>
          <a:xfrm>
            <a:off x="2446416" y="1059019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D8DD000-7D63-4715-BFC7-4EBB4BAB2A63}"/>
              </a:ext>
            </a:extLst>
          </p:cNvPr>
          <p:cNvSpPr txBox="1"/>
          <p:nvPr/>
        </p:nvSpPr>
        <p:spPr>
          <a:xfrm>
            <a:off x="2684876" y="77083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24F7A8D-A2AF-4F65-AD4D-B336D8AC6F1C}"/>
              </a:ext>
            </a:extLst>
          </p:cNvPr>
          <p:cNvCxnSpPr>
            <a:cxnSpLocks/>
          </p:cNvCxnSpPr>
          <p:nvPr/>
        </p:nvCxnSpPr>
        <p:spPr>
          <a:xfrm>
            <a:off x="3450460" y="1058587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C133360D-78FF-44A9-BCC8-92CE23A00811}"/>
              </a:ext>
            </a:extLst>
          </p:cNvPr>
          <p:cNvSpPr txBox="1"/>
          <p:nvPr/>
        </p:nvSpPr>
        <p:spPr>
          <a:xfrm>
            <a:off x="3688920" y="770398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0D14293-85B6-4541-BB01-A73B79E4EF52}"/>
              </a:ext>
            </a:extLst>
          </p:cNvPr>
          <p:cNvSpPr txBox="1"/>
          <p:nvPr/>
        </p:nvSpPr>
        <p:spPr>
          <a:xfrm>
            <a:off x="281579" y="3740585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2</a:t>
            </a:r>
            <a:endParaRPr lang="en-150" dirty="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3AB38675-82FC-4618-AFE1-6C41DA1207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4" t="88" r="5428" b="28686"/>
          <a:stretch/>
        </p:blipFill>
        <p:spPr>
          <a:xfrm>
            <a:off x="1064904" y="2232889"/>
            <a:ext cx="3801192" cy="1507696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5889354-85D2-45DF-98C6-EB0F4B8303F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8" t="-954" r="4745" b="19943"/>
          <a:stretch/>
        </p:blipFill>
        <p:spPr>
          <a:xfrm>
            <a:off x="1070959" y="4598341"/>
            <a:ext cx="3718831" cy="1351222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0D5E2BB-0688-4F2D-A99E-A6B82A77641A}"/>
              </a:ext>
            </a:extLst>
          </p:cNvPr>
          <p:cNvSpPr txBox="1"/>
          <p:nvPr/>
        </p:nvSpPr>
        <p:spPr>
          <a:xfrm>
            <a:off x="4832822" y="3386668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848DC87-7D68-46B4-8F05-A37B3ABC63AF}"/>
              </a:ext>
            </a:extLst>
          </p:cNvPr>
          <p:cNvSpPr txBox="1"/>
          <p:nvPr/>
        </p:nvSpPr>
        <p:spPr>
          <a:xfrm>
            <a:off x="4843867" y="5499117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A15ED637-D9C1-43CE-B356-35D48BBDC8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56" t="39963" b="23104"/>
          <a:stretch/>
        </p:blipFill>
        <p:spPr>
          <a:xfrm>
            <a:off x="1049443" y="1484253"/>
            <a:ext cx="3795137" cy="749515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571346D2-A284-4FD7-8233-181E0E24AE49}"/>
              </a:ext>
            </a:extLst>
          </p:cNvPr>
          <p:cNvSpPr txBox="1"/>
          <p:nvPr/>
        </p:nvSpPr>
        <p:spPr>
          <a:xfrm>
            <a:off x="4828838" y="1930590"/>
            <a:ext cx="1043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N-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DGKk</a:t>
            </a:r>
            <a:endParaRPr lang="en-150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EF9F412-9156-4443-A6C5-04E62A2D6B5D}"/>
              </a:ext>
            </a:extLst>
          </p:cNvPr>
          <p:cNvSpPr txBox="1"/>
          <p:nvPr/>
        </p:nvSpPr>
        <p:spPr>
          <a:xfrm>
            <a:off x="4832820" y="1703739"/>
            <a:ext cx="1043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FL-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DGKk</a:t>
            </a:r>
            <a:endParaRPr lang="en-150" sz="1200" dirty="0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E070B052-601E-49EB-BCF2-7991ABAD2F1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700" r="8058" b="27705"/>
          <a:stretch/>
        </p:blipFill>
        <p:spPr>
          <a:xfrm>
            <a:off x="1070959" y="3747730"/>
            <a:ext cx="3795137" cy="844509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2858036B-5716-423C-97BD-12898FDBEBAC}"/>
              </a:ext>
            </a:extLst>
          </p:cNvPr>
          <p:cNvSpPr txBox="1"/>
          <p:nvPr/>
        </p:nvSpPr>
        <p:spPr>
          <a:xfrm>
            <a:off x="4836944" y="4315240"/>
            <a:ext cx="1043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N-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DGKk</a:t>
            </a:r>
            <a:endParaRPr lang="en-150" sz="12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9219C9B-D511-4A35-92D8-82D271508E1D}"/>
              </a:ext>
            </a:extLst>
          </p:cNvPr>
          <p:cNvSpPr txBox="1"/>
          <p:nvPr/>
        </p:nvSpPr>
        <p:spPr>
          <a:xfrm>
            <a:off x="4838736" y="4081273"/>
            <a:ext cx="1043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FL-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DGKk</a:t>
            </a:r>
            <a:endParaRPr lang="en-150" sz="1200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D61B664-11B1-446C-B633-3A4EBAA998EC}"/>
              </a:ext>
            </a:extLst>
          </p:cNvPr>
          <p:cNvSpPr/>
          <p:nvPr/>
        </p:nvSpPr>
        <p:spPr>
          <a:xfrm>
            <a:off x="1069167" y="3765050"/>
            <a:ext cx="3795137" cy="219714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902736E-689C-46E8-A982-7E445BC44A75}"/>
              </a:ext>
            </a:extLst>
          </p:cNvPr>
          <p:cNvSpPr/>
          <p:nvPr/>
        </p:nvSpPr>
        <p:spPr>
          <a:xfrm>
            <a:off x="1070959" y="1476194"/>
            <a:ext cx="3793345" cy="228141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F30C8AD2-EC49-481B-816B-03F7A2D291B6}"/>
              </a:ext>
            </a:extLst>
          </p:cNvPr>
          <p:cNvCxnSpPr>
            <a:cxnSpLocks/>
          </p:cNvCxnSpPr>
          <p:nvPr/>
        </p:nvCxnSpPr>
        <p:spPr>
          <a:xfrm>
            <a:off x="1066696" y="2228711"/>
            <a:ext cx="37976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9F7E5D0-70A1-4DBE-81CA-1D956817B8F1}"/>
              </a:ext>
            </a:extLst>
          </p:cNvPr>
          <p:cNvCxnSpPr/>
          <p:nvPr/>
        </p:nvCxnSpPr>
        <p:spPr>
          <a:xfrm flipH="1">
            <a:off x="969174" y="184136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CCC85B0D-1045-43DF-8604-065CB0B3EB75}"/>
              </a:ext>
            </a:extLst>
          </p:cNvPr>
          <p:cNvCxnSpPr/>
          <p:nvPr/>
        </p:nvCxnSpPr>
        <p:spPr>
          <a:xfrm flipH="1">
            <a:off x="978885" y="2159151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CC676151-0EA3-43CE-A3DF-3F0AEA50672F}"/>
              </a:ext>
            </a:extLst>
          </p:cNvPr>
          <p:cNvSpPr txBox="1"/>
          <p:nvPr/>
        </p:nvSpPr>
        <p:spPr>
          <a:xfrm>
            <a:off x="619203" y="2022817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109F79B-7BBF-44B3-81DA-D6EEA708E861}"/>
              </a:ext>
            </a:extLst>
          </p:cNvPr>
          <p:cNvSpPr txBox="1"/>
          <p:nvPr/>
        </p:nvSpPr>
        <p:spPr>
          <a:xfrm>
            <a:off x="614978" y="169888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EDFA1D4-8D17-40C2-B63E-BB9324C211D2}"/>
              </a:ext>
            </a:extLst>
          </p:cNvPr>
          <p:cNvCxnSpPr/>
          <p:nvPr/>
        </p:nvCxnSpPr>
        <p:spPr>
          <a:xfrm flipH="1">
            <a:off x="972445" y="241851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24AA5AE9-F50B-4CD8-911D-AB9C9C68463E}"/>
              </a:ext>
            </a:extLst>
          </p:cNvPr>
          <p:cNvCxnSpPr/>
          <p:nvPr/>
        </p:nvCxnSpPr>
        <p:spPr>
          <a:xfrm flipH="1">
            <a:off x="979509" y="264475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85A98AC5-08AD-4052-82BC-AB1F5D469293}"/>
              </a:ext>
            </a:extLst>
          </p:cNvPr>
          <p:cNvSpPr txBox="1"/>
          <p:nvPr/>
        </p:nvSpPr>
        <p:spPr>
          <a:xfrm>
            <a:off x="702328" y="250988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9F788891-B773-4380-BFE1-65281FFF812B}"/>
              </a:ext>
            </a:extLst>
          </p:cNvPr>
          <p:cNvCxnSpPr/>
          <p:nvPr/>
        </p:nvCxnSpPr>
        <p:spPr>
          <a:xfrm flipH="1">
            <a:off x="985301" y="294923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96D7AE97-A3A4-4919-B58C-A81F4188B3EF}"/>
              </a:ext>
            </a:extLst>
          </p:cNvPr>
          <p:cNvSpPr txBox="1"/>
          <p:nvPr/>
        </p:nvSpPr>
        <p:spPr>
          <a:xfrm>
            <a:off x="712718" y="2810734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2B4987F-5305-4BA4-B3F6-557B5495BBDF}"/>
              </a:ext>
            </a:extLst>
          </p:cNvPr>
          <p:cNvSpPr txBox="1"/>
          <p:nvPr/>
        </p:nvSpPr>
        <p:spPr>
          <a:xfrm>
            <a:off x="623988" y="228965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405CF8AF-4828-4663-816D-F8FECA7FD732}"/>
              </a:ext>
            </a:extLst>
          </p:cNvPr>
          <p:cNvCxnSpPr/>
          <p:nvPr/>
        </p:nvCxnSpPr>
        <p:spPr>
          <a:xfrm flipH="1">
            <a:off x="976118" y="351253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61370E5E-0006-4A8B-AF68-A1F0755FF196}"/>
              </a:ext>
            </a:extLst>
          </p:cNvPr>
          <p:cNvSpPr txBox="1"/>
          <p:nvPr/>
        </p:nvSpPr>
        <p:spPr>
          <a:xfrm>
            <a:off x="703535" y="337403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pic>
        <p:nvPicPr>
          <p:cNvPr id="63" name="Graphic 62" descr="Scissors">
            <a:extLst>
              <a:ext uri="{FF2B5EF4-FFF2-40B4-BE49-F238E27FC236}">
                <a16:creationId xmlns:a16="http://schemas.microsoft.com/office/drawing/2014/main" id="{178F751A-7FDE-40A0-9796-5B72B41DF4D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 rot="2735044">
            <a:off x="4916795" y="2089266"/>
            <a:ext cx="304402" cy="304402"/>
          </a:xfrm>
          <a:prstGeom prst="rect">
            <a:avLst/>
          </a:prstGeom>
        </p:spPr>
      </p:pic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DC592B62-0177-4E75-BC52-D0DF2A20434E}"/>
              </a:ext>
            </a:extLst>
          </p:cNvPr>
          <p:cNvCxnSpPr>
            <a:cxnSpLocks/>
          </p:cNvCxnSpPr>
          <p:nvPr/>
        </p:nvCxnSpPr>
        <p:spPr>
          <a:xfrm>
            <a:off x="1064904" y="4592239"/>
            <a:ext cx="37976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13AD2A52-4903-4C84-AD36-A3DBFB3D8EEA}"/>
              </a:ext>
            </a:extLst>
          </p:cNvPr>
          <p:cNvCxnSpPr/>
          <p:nvPr/>
        </p:nvCxnSpPr>
        <p:spPr>
          <a:xfrm flipH="1">
            <a:off x="976514" y="4165151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0BECE766-695E-46D2-BCDB-CF3F45A7FDAA}"/>
              </a:ext>
            </a:extLst>
          </p:cNvPr>
          <p:cNvCxnSpPr/>
          <p:nvPr/>
        </p:nvCxnSpPr>
        <p:spPr>
          <a:xfrm flipH="1">
            <a:off x="986225" y="448293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453B2775-D865-4188-A541-6D72831F69E9}"/>
              </a:ext>
            </a:extLst>
          </p:cNvPr>
          <p:cNvSpPr txBox="1"/>
          <p:nvPr/>
        </p:nvSpPr>
        <p:spPr>
          <a:xfrm>
            <a:off x="626543" y="4346604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95C427A-7095-4502-BC86-85B1FEB0CB8D}"/>
              </a:ext>
            </a:extLst>
          </p:cNvPr>
          <p:cNvSpPr txBox="1"/>
          <p:nvPr/>
        </p:nvSpPr>
        <p:spPr>
          <a:xfrm>
            <a:off x="622318" y="4022669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3076655-9B96-49C1-839C-3E82FF49A3E0}"/>
              </a:ext>
            </a:extLst>
          </p:cNvPr>
          <p:cNvSpPr txBox="1"/>
          <p:nvPr/>
        </p:nvSpPr>
        <p:spPr>
          <a:xfrm>
            <a:off x="676753" y="1168199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6775D5FB-E054-4B7B-8D33-DB6040D7DB4F}"/>
              </a:ext>
            </a:extLst>
          </p:cNvPr>
          <p:cNvCxnSpPr/>
          <p:nvPr/>
        </p:nvCxnSpPr>
        <p:spPr>
          <a:xfrm flipH="1">
            <a:off x="978302" y="474250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27113FB1-19B5-4839-B1FA-CBC1967B3D61}"/>
              </a:ext>
            </a:extLst>
          </p:cNvPr>
          <p:cNvSpPr txBox="1"/>
          <p:nvPr/>
        </p:nvSpPr>
        <p:spPr>
          <a:xfrm>
            <a:off x="701121" y="460763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0E5A327-8065-4B83-BC96-5C7ABE9D814F}"/>
              </a:ext>
            </a:extLst>
          </p:cNvPr>
          <p:cNvCxnSpPr/>
          <p:nvPr/>
        </p:nvCxnSpPr>
        <p:spPr>
          <a:xfrm flipH="1">
            <a:off x="984094" y="504698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29F63299-EDE1-4592-8387-D0C02C937161}"/>
              </a:ext>
            </a:extLst>
          </p:cNvPr>
          <p:cNvSpPr txBox="1"/>
          <p:nvPr/>
        </p:nvSpPr>
        <p:spPr>
          <a:xfrm>
            <a:off x="711511" y="4908484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14C7F93-4FE9-4C23-8240-26956E0426FB}"/>
              </a:ext>
            </a:extLst>
          </p:cNvPr>
          <p:cNvCxnSpPr/>
          <p:nvPr/>
        </p:nvCxnSpPr>
        <p:spPr>
          <a:xfrm flipH="1">
            <a:off x="974911" y="561028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5C7A113-9BF2-479F-8957-01D0CF021EA3}"/>
              </a:ext>
            </a:extLst>
          </p:cNvPr>
          <p:cNvSpPr txBox="1"/>
          <p:nvPr/>
        </p:nvSpPr>
        <p:spPr>
          <a:xfrm>
            <a:off x="702328" y="547178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pic>
        <p:nvPicPr>
          <p:cNvPr id="80" name="Graphic 79" descr="Scissors">
            <a:extLst>
              <a:ext uri="{FF2B5EF4-FFF2-40B4-BE49-F238E27FC236}">
                <a16:creationId xmlns:a16="http://schemas.microsoft.com/office/drawing/2014/main" id="{89B7F026-76DF-4546-AB80-E72CADD4F11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 rot="2735044">
            <a:off x="4916793" y="4437349"/>
            <a:ext cx="304402" cy="304402"/>
          </a:xfrm>
          <a:prstGeom prst="rect">
            <a:avLst/>
          </a:prstGeom>
        </p:spPr>
      </p:pic>
      <p:sp>
        <p:nvSpPr>
          <p:cNvPr id="81" name="Rectangle 80">
            <a:extLst>
              <a:ext uri="{FF2B5EF4-FFF2-40B4-BE49-F238E27FC236}">
                <a16:creationId xmlns:a16="http://schemas.microsoft.com/office/drawing/2014/main" id="{F1056285-F276-4CF0-9572-802D34DF83E0}"/>
              </a:ext>
            </a:extLst>
          </p:cNvPr>
          <p:cNvSpPr/>
          <p:nvPr/>
        </p:nvSpPr>
        <p:spPr>
          <a:xfrm>
            <a:off x="1227648" y="4079190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9316CAD4-BE13-4BFE-AFF0-D5A882165B97}"/>
              </a:ext>
            </a:extLst>
          </p:cNvPr>
          <p:cNvSpPr/>
          <p:nvPr/>
        </p:nvSpPr>
        <p:spPr>
          <a:xfrm>
            <a:off x="1227648" y="5355422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48747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29E3E5C3-CE61-4CA3-89F6-31BCE4BB38D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9" t="22306" r="9940" b="19381"/>
          <a:stretch/>
        </p:blipFill>
        <p:spPr>
          <a:xfrm>
            <a:off x="6703389" y="2075645"/>
            <a:ext cx="3590821" cy="153594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48B0F9D-CD5D-4E25-9F42-0BDB664F79B7}"/>
              </a:ext>
            </a:extLst>
          </p:cNvPr>
          <p:cNvSpPr txBox="1"/>
          <p:nvPr/>
        </p:nvSpPr>
        <p:spPr>
          <a:xfrm>
            <a:off x="100390" y="80339"/>
            <a:ext cx="8439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xp2.:</a:t>
            </a:r>
            <a:endParaRPr lang="en-15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DA997D-738D-47FD-8D9C-440481EE476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1" t="13127" r="11373" b="134"/>
          <a:stretch/>
        </p:blipFill>
        <p:spPr>
          <a:xfrm>
            <a:off x="967554" y="4876275"/>
            <a:ext cx="3701255" cy="138535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6B7D0FE-2BC7-45E1-8AB7-AF8977B699E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5" t="21226" r="10114" b="-176"/>
          <a:stretch/>
        </p:blipFill>
        <p:spPr>
          <a:xfrm>
            <a:off x="919417" y="2285255"/>
            <a:ext cx="3734963" cy="14352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E598A79-B603-4709-82E7-4698FCE61E4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8" t="-1671" r="9258" b="-2218"/>
          <a:stretch/>
        </p:blipFill>
        <p:spPr>
          <a:xfrm>
            <a:off x="930593" y="1389186"/>
            <a:ext cx="3723788" cy="91996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8E4E64A-64C9-4DB3-9911-5622AFDCF49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0" t="17217" r="9578" b="6520"/>
          <a:stretch/>
        </p:blipFill>
        <p:spPr>
          <a:xfrm>
            <a:off x="937475" y="3936649"/>
            <a:ext cx="3739566" cy="93790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8525F9C-F33B-449A-9F56-C65994F82D77}"/>
              </a:ext>
            </a:extLst>
          </p:cNvPr>
          <p:cNvSpPr txBox="1"/>
          <p:nvPr/>
        </p:nvSpPr>
        <p:spPr>
          <a:xfrm>
            <a:off x="1265721" y="1102669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5611E3-9188-4BA7-9295-EB015DC1BF8C}"/>
              </a:ext>
            </a:extLst>
          </p:cNvPr>
          <p:cNvSpPr txBox="1"/>
          <p:nvPr/>
        </p:nvSpPr>
        <p:spPr>
          <a:xfrm>
            <a:off x="4428471" y="1102668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F0F3545-85B6-4660-A34C-5775309D64CB}"/>
              </a:ext>
            </a:extLst>
          </p:cNvPr>
          <p:cNvCxnSpPr>
            <a:cxnSpLocks/>
          </p:cNvCxnSpPr>
          <p:nvPr/>
        </p:nvCxnSpPr>
        <p:spPr>
          <a:xfrm>
            <a:off x="1384056" y="975359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9B6818FB-E85F-4922-9946-D9C4E98C2616}"/>
              </a:ext>
            </a:extLst>
          </p:cNvPr>
          <p:cNvSpPr txBox="1"/>
          <p:nvPr/>
        </p:nvSpPr>
        <p:spPr>
          <a:xfrm>
            <a:off x="1622516" y="68717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0766D2B-3A18-46F6-858C-C15788993A8A}"/>
              </a:ext>
            </a:extLst>
          </p:cNvPr>
          <p:cNvCxnSpPr>
            <a:cxnSpLocks/>
          </p:cNvCxnSpPr>
          <p:nvPr/>
        </p:nvCxnSpPr>
        <p:spPr>
          <a:xfrm>
            <a:off x="2418583" y="975791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E35B716-8BF9-44BF-845A-DC80B49696C5}"/>
              </a:ext>
            </a:extLst>
          </p:cNvPr>
          <p:cNvSpPr txBox="1"/>
          <p:nvPr/>
        </p:nvSpPr>
        <p:spPr>
          <a:xfrm>
            <a:off x="2657043" y="68760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3F6A344-6B54-4322-B5A7-9C314A09B7D2}"/>
              </a:ext>
            </a:extLst>
          </p:cNvPr>
          <p:cNvCxnSpPr>
            <a:cxnSpLocks/>
          </p:cNvCxnSpPr>
          <p:nvPr/>
        </p:nvCxnSpPr>
        <p:spPr>
          <a:xfrm>
            <a:off x="3422627" y="975359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C24A087-3966-4B5C-8F96-83BF079F43BA}"/>
              </a:ext>
            </a:extLst>
          </p:cNvPr>
          <p:cNvSpPr txBox="1"/>
          <p:nvPr/>
        </p:nvSpPr>
        <p:spPr>
          <a:xfrm>
            <a:off x="3661087" y="68717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30DB24-142E-4C41-AA9C-F1FDF6799E20}"/>
              </a:ext>
            </a:extLst>
          </p:cNvPr>
          <p:cNvSpPr txBox="1"/>
          <p:nvPr/>
        </p:nvSpPr>
        <p:spPr>
          <a:xfrm>
            <a:off x="4642266" y="1593742"/>
            <a:ext cx="9157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-mTOR (Ser2448)</a:t>
            </a:r>
            <a:endParaRPr lang="en-150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25BE748-58CD-4F12-BE26-077681AECEAF}"/>
              </a:ext>
            </a:extLst>
          </p:cNvPr>
          <p:cNvSpPr txBox="1"/>
          <p:nvPr/>
        </p:nvSpPr>
        <p:spPr>
          <a:xfrm>
            <a:off x="4663434" y="4177477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TOR</a:t>
            </a:r>
            <a:endParaRPr lang="en-150" sz="12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47DC545-58F8-404B-AECB-0FA232D0DF9A}"/>
              </a:ext>
            </a:extLst>
          </p:cNvPr>
          <p:cNvSpPr txBox="1"/>
          <p:nvPr/>
        </p:nvSpPr>
        <p:spPr>
          <a:xfrm>
            <a:off x="4658090" y="2742794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F230A5-4374-495D-B2E1-43C0C677BEBE}"/>
              </a:ext>
            </a:extLst>
          </p:cNvPr>
          <p:cNvSpPr txBox="1"/>
          <p:nvPr/>
        </p:nvSpPr>
        <p:spPr>
          <a:xfrm>
            <a:off x="4698216" y="5755331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7E85523-C155-44AB-9737-575A4F456B94}"/>
              </a:ext>
            </a:extLst>
          </p:cNvPr>
          <p:cNvSpPr/>
          <p:nvPr/>
        </p:nvSpPr>
        <p:spPr>
          <a:xfrm>
            <a:off x="921697" y="1379667"/>
            <a:ext cx="3739566" cy="23407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75FFEFF-052A-4A8C-9E2C-0E5162B334BF}"/>
              </a:ext>
            </a:extLst>
          </p:cNvPr>
          <p:cNvSpPr/>
          <p:nvPr/>
        </p:nvSpPr>
        <p:spPr>
          <a:xfrm>
            <a:off x="923710" y="3935318"/>
            <a:ext cx="3751317" cy="23407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51ACC6E-09E6-4CB5-ABF4-B19DCBB0FA35}"/>
              </a:ext>
            </a:extLst>
          </p:cNvPr>
          <p:cNvSpPr txBox="1"/>
          <p:nvPr/>
        </p:nvSpPr>
        <p:spPr>
          <a:xfrm>
            <a:off x="62924" y="1414317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5</a:t>
            </a:r>
            <a:endParaRPr lang="en-15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72853DD-4FA1-4D9D-AF4C-C9646D833076}"/>
              </a:ext>
            </a:extLst>
          </p:cNvPr>
          <p:cNvSpPr txBox="1"/>
          <p:nvPr/>
        </p:nvSpPr>
        <p:spPr>
          <a:xfrm>
            <a:off x="34596" y="4034194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6</a:t>
            </a:r>
            <a:endParaRPr lang="en-150" dirty="0"/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BD899B66-ADC3-41E8-9682-06A89A35FB3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2" t="22858" r="12561" b="4125"/>
          <a:stretch/>
        </p:blipFill>
        <p:spPr>
          <a:xfrm>
            <a:off x="6575122" y="3693765"/>
            <a:ext cx="3693997" cy="150863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9F0374F-08B3-4FB5-8EE2-7D26B6A1DA9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1" t="31597" r="6340" b="11543"/>
          <a:stretch/>
        </p:blipFill>
        <p:spPr>
          <a:xfrm>
            <a:off x="6629208" y="636874"/>
            <a:ext cx="3689654" cy="141633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F2B8CF4-A187-445E-A37F-6DCA3406E3E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3" t="5" r="10240" b="18988"/>
          <a:stretch/>
        </p:blipFill>
        <p:spPr>
          <a:xfrm>
            <a:off x="6665632" y="5213596"/>
            <a:ext cx="3653609" cy="1568672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7519A712-4DC5-48EC-A9FE-EB0C9CF75E44}"/>
              </a:ext>
            </a:extLst>
          </p:cNvPr>
          <p:cNvSpPr txBox="1"/>
          <p:nvPr/>
        </p:nvSpPr>
        <p:spPr>
          <a:xfrm>
            <a:off x="10342184" y="2887177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-EIF4E</a:t>
            </a:r>
            <a:endParaRPr lang="en-150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7F50D67-52E2-4A66-AC79-4719BEE5AB5E}"/>
              </a:ext>
            </a:extLst>
          </p:cNvPr>
          <p:cNvSpPr txBox="1"/>
          <p:nvPr/>
        </p:nvSpPr>
        <p:spPr>
          <a:xfrm>
            <a:off x="10325851" y="6029669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IF4E</a:t>
            </a:r>
            <a:endParaRPr lang="en-150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FE91AA-8EEB-4428-99A4-58A5A4DE312C}"/>
              </a:ext>
            </a:extLst>
          </p:cNvPr>
          <p:cNvSpPr txBox="1"/>
          <p:nvPr/>
        </p:nvSpPr>
        <p:spPr>
          <a:xfrm>
            <a:off x="10318862" y="989429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3160334C-BE0B-4C69-8FE6-2649C5C5E143}"/>
              </a:ext>
            </a:extLst>
          </p:cNvPr>
          <p:cNvSpPr/>
          <p:nvPr/>
        </p:nvSpPr>
        <p:spPr>
          <a:xfrm>
            <a:off x="6633978" y="649307"/>
            <a:ext cx="3693997" cy="298030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901A556-7FC8-49A8-AE95-58736CAF1DD7}"/>
              </a:ext>
            </a:extLst>
          </p:cNvPr>
          <p:cNvSpPr txBox="1"/>
          <p:nvPr/>
        </p:nvSpPr>
        <p:spPr>
          <a:xfrm>
            <a:off x="5778059" y="266201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1</a:t>
            </a:r>
            <a:endParaRPr lang="en-15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0E26091-7A5C-46E7-82C3-11F744314D49}"/>
              </a:ext>
            </a:extLst>
          </p:cNvPr>
          <p:cNvSpPr txBox="1"/>
          <p:nvPr/>
        </p:nvSpPr>
        <p:spPr>
          <a:xfrm>
            <a:off x="10319076" y="4162987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793F27A4-4E54-4AF2-862A-9211BAAB649D}"/>
              </a:ext>
            </a:extLst>
          </p:cNvPr>
          <p:cNvSpPr/>
          <p:nvPr/>
        </p:nvSpPr>
        <p:spPr>
          <a:xfrm>
            <a:off x="6638629" y="3693765"/>
            <a:ext cx="3693997" cy="310244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670153B-CB2F-4BCB-BC96-A9DFCC3E0C7A}"/>
              </a:ext>
            </a:extLst>
          </p:cNvPr>
          <p:cNvSpPr txBox="1"/>
          <p:nvPr/>
        </p:nvSpPr>
        <p:spPr>
          <a:xfrm>
            <a:off x="5844544" y="3605007"/>
            <a:ext cx="528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2</a:t>
            </a:r>
            <a:endParaRPr lang="en-15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CBE3D17-479D-49EE-94A7-68DD9E91371D}"/>
              </a:ext>
            </a:extLst>
          </p:cNvPr>
          <p:cNvSpPr txBox="1"/>
          <p:nvPr/>
        </p:nvSpPr>
        <p:spPr>
          <a:xfrm>
            <a:off x="6965671" y="343280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D9D3117-F398-4BF1-B624-96C4B2D96ED9}"/>
              </a:ext>
            </a:extLst>
          </p:cNvPr>
          <p:cNvSpPr txBox="1"/>
          <p:nvPr/>
        </p:nvSpPr>
        <p:spPr>
          <a:xfrm>
            <a:off x="10128421" y="343279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117ADD5-EB6C-4E11-9767-17146800052F}"/>
              </a:ext>
            </a:extLst>
          </p:cNvPr>
          <p:cNvCxnSpPr>
            <a:cxnSpLocks/>
          </p:cNvCxnSpPr>
          <p:nvPr/>
        </p:nvCxnSpPr>
        <p:spPr>
          <a:xfrm>
            <a:off x="7084006" y="349532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C42F60FF-8612-4651-942C-48B4A93F3AA4}"/>
              </a:ext>
            </a:extLst>
          </p:cNvPr>
          <p:cNvSpPr txBox="1"/>
          <p:nvPr/>
        </p:nvSpPr>
        <p:spPr>
          <a:xfrm>
            <a:off x="7322466" y="61343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ED397EB8-1AFC-4C66-BD1D-3EFB0D69ABA6}"/>
              </a:ext>
            </a:extLst>
          </p:cNvPr>
          <p:cNvCxnSpPr>
            <a:cxnSpLocks/>
          </p:cNvCxnSpPr>
          <p:nvPr/>
        </p:nvCxnSpPr>
        <p:spPr>
          <a:xfrm>
            <a:off x="8118533" y="349964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FBC74E76-1E01-4F73-BD5F-5CB2955D07BD}"/>
              </a:ext>
            </a:extLst>
          </p:cNvPr>
          <p:cNvSpPr txBox="1"/>
          <p:nvPr/>
        </p:nvSpPr>
        <p:spPr>
          <a:xfrm>
            <a:off x="8356993" y="61775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43617775-9C1E-481A-9736-970FEA0DD8D0}"/>
              </a:ext>
            </a:extLst>
          </p:cNvPr>
          <p:cNvCxnSpPr>
            <a:cxnSpLocks/>
          </p:cNvCxnSpPr>
          <p:nvPr/>
        </p:nvCxnSpPr>
        <p:spPr>
          <a:xfrm>
            <a:off x="9122577" y="349532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F2B23468-19E2-4663-96FD-11EFC6BC8BFF}"/>
              </a:ext>
            </a:extLst>
          </p:cNvPr>
          <p:cNvSpPr txBox="1"/>
          <p:nvPr/>
        </p:nvSpPr>
        <p:spPr>
          <a:xfrm>
            <a:off x="9361037" y="61343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1984375-CF45-4F43-9DB4-C1B8B7EC87EE}"/>
              </a:ext>
            </a:extLst>
          </p:cNvPr>
          <p:cNvCxnSpPr>
            <a:cxnSpLocks/>
          </p:cNvCxnSpPr>
          <p:nvPr/>
        </p:nvCxnSpPr>
        <p:spPr>
          <a:xfrm>
            <a:off x="916059" y="4866099"/>
            <a:ext cx="37527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7AAD942D-D3AD-44F8-9001-5DABF7AF044C}"/>
              </a:ext>
            </a:extLst>
          </p:cNvPr>
          <p:cNvCxnSpPr>
            <a:cxnSpLocks/>
          </p:cNvCxnSpPr>
          <p:nvPr/>
        </p:nvCxnSpPr>
        <p:spPr>
          <a:xfrm>
            <a:off x="924291" y="2284483"/>
            <a:ext cx="37527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15CF407B-63AF-4C52-95DC-E6553764451D}"/>
              </a:ext>
            </a:extLst>
          </p:cNvPr>
          <p:cNvCxnSpPr>
            <a:cxnSpLocks/>
          </p:cNvCxnSpPr>
          <p:nvPr/>
        </p:nvCxnSpPr>
        <p:spPr>
          <a:xfrm>
            <a:off x="6636349" y="5201826"/>
            <a:ext cx="3702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06D440D9-9FC8-4663-AA20-ED662442CDEA}"/>
              </a:ext>
            </a:extLst>
          </p:cNvPr>
          <p:cNvCxnSpPr>
            <a:cxnSpLocks/>
          </p:cNvCxnSpPr>
          <p:nvPr/>
        </p:nvCxnSpPr>
        <p:spPr>
          <a:xfrm>
            <a:off x="6625332" y="2059047"/>
            <a:ext cx="3702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380E5A4-2112-4AFD-9455-A69045F93299}"/>
              </a:ext>
            </a:extLst>
          </p:cNvPr>
          <p:cNvCxnSpPr>
            <a:cxnSpLocks/>
          </p:cNvCxnSpPr>
          <p:nvPr/>
        </p:nvCxnSpPr>
        <p:spPr>
          <a:xfrm flipV="1">
            <a:off x="10645316" y="4403526"/>
            <a:ext cx="0" cy="162614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39E14251-CCF8-4827-AD48-712D8E023E7A}"/>
              </a:ext>
            </a:extLst>
          </p:cNvPr>
          <p:cNvSpPr txBox="1"/>
          <p:nvPr/>
        </p:nvSpPr>
        <p:spPr>
          <a:xfrm>
            <a:off x="10625380" y="4994553"/>
            <a:ext cx="77455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H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r>
              <a:rPr lang="en-US" sz="1200" dirty="0">
                <a:solidFill>
                  <a:srgbClr val="FF0000"/>
                </a:solidFill>
              </a:rPr>
              <a:t>O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endParaRPr lang="en-150" sz="1200" dirty="0">
              <a:solidFill>
                <a:srgbClr val="FF0000"/>
              </a:solidFill>
            </a:endParaRP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ABDAD1A2-BCDE-4C46-AECC-52313B6D95D2}"/>
              </a:ext>
            </a:extLst>
          </p:cNvPr>
          <p:cNvCxnSpPr>
            <a:cxnSpLocks/>
          </p:cNvCxnSpPr>
          <p:nvPr/>
        </p:nvCxnSpPr>
        <p:spPr>
          <a:xfrm flipV="1">
            <a:off x="10594384" y="1327338"/>
            <a:ext cx="0" cy="151627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1F9EAF88-16E0-4CA5-85D9-E00D473F2E9D}"/>
              </a:ext>
            </a:extLst>
          </p:cNvPr>
          <p:cNvSpPr txBox="1"/>
          <p:nvPr/>
        </p:nvSpPr>
        <p:spPr>
          <a:xfrm>
            <a:off x="10594384" y="1976024"/>
            <a:ext cx="77455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H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r>
              <a:rPr lang="en-US" sz="1200" dirty="0">
                <a:solidFill>
                  <a:srgbClr val="FF0000"/>
                </a:solidFill>
              </a:rPr>
              <a:t>O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endParaRPr lang="en-150" sz="1200" dirty="0">
              <a:solidFill>
                <a:srgbClr val="FF0000"/>
              </a:solidFill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652F7625-E387-4E42-93CF-7C8DBA92D0A8}"/>
              </a:ext>
            </a:extLst>
          </p:cNvPr>
          <p:cNvCxnSpPr/>
          <p:nvPr/>
        </p:nvCxnSpPr>
        <p:spPr>
          <a:xfrm flipH="1">
            <a:off x="839814" y="179654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07001103-9DF2-4EF2-A702-1515593053C9}"/>
              </a:ext>
            </a:extLst>
          </p:cNvPr>
          <p:cNvSpPr txBox="1"/>
          <p:nvPr/>
        </p:nvSpPr>
        <p:spPr>
          <a:xfrm>
            <a:off x="485674" y="1654667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6BEF48B7-C2C3-4778-95B3-6280B9977123}"/>
              </a:ext>
            </a:extLst>
          </p:cNvPr>
          <p:cNvCxnSpPr/>
          <p:nvPr/>
        </p:nvCxnSpPr>
        <p:spPr>
          <a:xfrm flipH="1">
            <a:off x="843915" y="194251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AA32B792-16DF-4FB2-B46B-16A5AFB81D2D}"/>
              </a:ext>
            </a:extLst>
          </p:cNvPr>
          <p:cNvSpPr txBox="1"/>
          <p:nvPr/>
        </p:nvSpPr>
        <p:spPr>
          <a:xfrm>
            <a:off x="489775" y="180064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7817501-3D0A-4AE7-BC2D-41AA2A1E9540}"/>
              </a:ext>
            </a:extLst>
          </p:cNvPr>
          <p:cNvCxnSpPr/>
          <p:nvPr/>
        </p:nvCxnSpPr>
        <p:spPr>
          <a:xfrm flipH="1">
            <a:off x="843915" y="210347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947A126F-2F0C-4C2C-98D3-8471E8193D11}"/>
              </a:ext>
            </a:extLst>
          </p:cNvPr>
          <p:cNvSpPr txBox="1"/>
          <p:nvPr/>
        </p:nvSpPr>
        <p:spPr>
          <a:xfrm>
            <a:off x="489775" y="196160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1C75A902-AFB6-4E71-8F7C-771ABD91D7CC}"/>
              </a:ext>
            </a:extLst>
          </p:cNvPr>
          <p:cNvCxnSpPr/>
          <p:nvPr/>
        </p:nvCxnSpPr>
        <p:spPr>
          <a:xfrm flipH="1">
            <a:off x="835675" y="224804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AB321101-EBE0-4C32-BEAC-552926166389}"/>
              </a:ext>
            </a:extLst>
          </p:cNvPr>
          <p:cNvSpPr txBox="1"/>
          <p:nvPr/>
        </p:nvSpPr>
        <p:spPr>
          <a:xfrm>
            <a:off x="564775" y="210616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B9E42D48-0206-4F02-81EC-C5713D9FA59C}"/>
              </a:ext>
            </a:extLst>
          </p:cNvPr>
          <p:cNvCxnSpPr/>
          <p:nvPr/>
        </p:nvCxnSpPr>
        <p:spPr>
          <a:xfrm flipH="1">
            <a:off x="834250" y="242058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DB6356F2-375C-493F-A456-95D88880678F}"/>
              </a:ext>
            </a:extLst>
          </p:cNvPr>
          <p:cNvSpPr txBox="1"/>
          <p:nvPr/>
        </p:nvSpPr>
        <p:spPr>
          <a:xfrm>
            <a:off x="563350" y="2278707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810C9F6-0AD0-46D5-806D-BDFBDEB73740}"/>
              </a:ext>
            </a:extLst>
          </p:cNvPr>
          <p:cNvCxnSpPr/>
          <p:nvPr/>
        </p:nvCxnSpPr>
        <p:spPr>
          <a:xfrm flipH="1">
            <a:off x="830924" y="282753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153FD712-3375-4779-A763-A945082F98BF}"/>
              </a:ext>
            </a:extLst>
          </p:cNvPr>
          <p:cNvSpPr txBox="1"/>
          <p:nvPr/>
        </p:nvSpPr>
        <p:spPr>
          <a:xfrm>
            <a:off x="560024" y="268565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5E88BBFF-D923-423D-989E-561B28E65AD8}"/>
              </a:ext>
            </a:extLst>
          </p:cNvPr>
          <p:cNvCxnSpPr/>
          <p:nvPr/>
        </p:nvCxnSpPr>
        <p:spPr>
          <a:xfrm flipH="1">
            <a:off x="843916" y="3145795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4922396A-61E8-4B15-A603-E2B3A6063C1B}"/>
              </a:ext>
            </a:extLst>
          </p:cNvPr>
          <p:cNvSpPr txBox="1"/>
          <p:nvPr/>
        </p:nvSpPr>
        <p:spPr>
          <a:xfrm>
            <a:off x="573016" y="300391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pic>
        <p:nvPicPr>
          <p:cNvPr id="74" name="Graphic 73" descr="Scissors">
            <a:extLst>
              <a:ext uri="{FF2B5EF4-FFF2-40B4-BE49-F238E27FC236}">
                <a16:creationId xmlns:a16="http://schemas.microsoft.com/office/drawing/2014/main" id="{B627FA5B-F36A-46E5-BDCD-41AEBB09878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 rot="2735044">
            <a:off x="4730598" y="2133053"/>
            <a:ext cx="304402" cy="304402"/>
          </a:xfrm>
          <a:prstGeom prst="rect">
            <a:avLst/>
          </a:prstGeom>
        </p:spPr>
      </p:pic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505AE88C-3079-4518-A425-43BFF20C01FE}"/>
              </a:ext>
            </a:extLst>
          </p:cNvPr>
          <p:cNvCxnSpPr/>
          <p:nvPr/>
        </p:nvCxnSpPr>
        <p:spPr>
          <a:xfrm flipH="1">
            <a:off x="827823" y="434039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0FF6E528-9152-47BB-BF75-14620AB1E77C}"/>
              </a:ext>
            </a:extLst>
          </p:cNvPr>
          <p:cNvSpPr txBox="1"/>
          <p:nvPr/>
        </p:nvSpPr>
        <p:spPr>
          <a:xfrm>
            <a:off x="473683" y="419852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EF65D516-8132-4DD9-919A-EB1F9A2CF2D4}"/>
              </a:ext>
            </a:extLst>
          </p:cNvPr>
          <p:cNvCxnSpPr/>
          <p:nvPr/>
        </p:nvCxnSpPr>
        <p:spPr>
          <a:xfrm flipH="1">
            <a:off x="831924" y="448636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89373DF4-C548-461B-8AB8-C8409BAD3531}"/>
              </a:ext>
            </a:extLst>
          </p:cNvPr>
          <p:cNvSpPr txBox="1"/>
          <p:nvPr/>
        </p:nvSpPr>
        <p:spPr>
          <a:xfrm>
            <a:off x="477784" y="4344493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4989A76-15DA-4E6B-A995-100844A08F66}"/>
              </a:ext>
            </a:extLst>
          </p:cNvPr>
          <p:cNvCxnSpPr/>
          <p:nvPr/>
        </p:nvCxnSpPr>
        <p:spPr>
          <a:xfrm flipH="1">
            <a:off x="831924" y="462300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B7134B3C-CD85-48BC-8DB8-1907D21D4C1E}"/>
              </a:ext>
            </a:extLst>
          </p:cNvPr>
          <p:cNvSpPr txBox="1"/>
          <p:nvPr/>
        </p:nvSpPr>
        <p:spPr>
          <a:xfrm>
            <a:off x="477784" y="4481133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D1FBFE5B-0B56-4DCD-88D2-AEB4F0CA7B63}"/>
              </a:ext>
            </a:extLst>
          </p:cNvPr>
          <p:cNvCxnSpPr/>
          <p:nvPr/>
        </p:nvCxnSpPr>
        <p:spPr>
          <a:xfrm flipH="1">
            <a:off x="833412" y="476757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ED06BF65-A8D0-47A8-A80F-45A88A72CBFD}"/>
              </a:ext>
            </a:extLst>
          </p:cNvPr>
          <p:cNvSpPr txBox="1"/>
          <p:nvPr/>
        </p:nvSpPr>
        <p:spPr>
          <a:xfrm>
            <a:off x="561895" y="4625033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6192762F-0E3A-45D7-B515-2D157117228B}"/>
              </a:ext>
            </a:extLst>
          </p:cNvPr>
          <p:cNvCxnSpPr/>
          <p:nvPr/>
        </p:nvCxnSpPr>
        <p:spPr>
          <a:xfrm flipH="1">
            <a:off x="839195" y="5033495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7203EE79-16F1-4C08-A123-C61E63D313B8}"/>
              </a:ext>
            </a:extLst>
          </p:cNvPr>
          <p:cNvSpPr txBox="1"/>
          <p:nvPr/>
        </p:nvSpPr>
        <p:spPr>
          <a:xfrm>
            <a:off x="568295" y="489161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F017549F-E7F0-46DD-9344-EA713DEE7349}"/>
              </a:ext>
            </a:extLst>
          </p:cNvPr>
          <p:cNvCxnSpPr/>
          <p:nvPr/>
        </p:nvCxnSpPr>
        <p:spPr>
          <a:xfrm flipH="1">
            <a:off x="835869" y="544044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9E090BCD-30F7-4F2D-8404-304FC55D88CE}"/>
              </a:ext>
            </a:extLst>
          </p:cNvPr>
          <p:cNvSpPr txBox="1"/>
          <p:nvPr/>
        </p:nvSpPr>
        <p:spPr>
          <a:xfrm>
            <a:off x="564969" y="5298570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BD4C73DC-99E6-4026-9CFD-A22C90BCC2BD}"/>
              </a:ext>
            </a:extLst>
          </p:cNvPr>
          <p:cNvCxnSpPr/>
          <p:nvPr/>
        </p:nvCxnSpPr>
        <p:spPr>
          <a:xfrm flipH="1">
            <a:off x="848861" y="575870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72945B9E-A0EA-41A9-82E3-97EDF3E523DB}"/>
              </a:ext>
            </a:extLst>
          </p:cNvPr>
          <p:cNvSpPr txBox="1"/>
          <p:nvPr/>
        </p:nvSpPr>
        <p:spPr>
          <a:xfrm>
            <a:off x="577961" y="5616831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pic>
        <p:nvPicPr>
          <p:cNvPr id="93" name="Graphic 92" descr="Scissors">
            <a:extLst>
              <a:ext uri="{FF2B5EF4-FFF2-40B4-BE49-F238E27FC236}">
                <a16:creationId xmlns:a16="http://schemas.microsoft.com/office/drawing/2014/main" id="{8AE03A65-B7FA-43E9-A540-D1D693079BE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 rot="2735044">
            <a:off x="4766907" y="4700218"/>
            <a:ext cx="304402" cy="304402"/>
          </a:xfrm>
          <a:prstGeom prst="rect">
            <a:avLst/>
          </a:prstGeom>
        </p:spPr>
      </p:pic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CE5706AB-F3B6-44B3-AE48-AC5A4F481364}"/>
              </a:ext>
            </a:extLst>
          </p:cNvPr>
          <p:cNvCxnSpPr/>
          <p:nvPr/>
        </p:nvCxnSpPr>
        <p:spPr>
          <a:xfrm flipH="1">
            <a:off x="6538014" y="260947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B07B67DF-0713-49A7-ACA6-DABB602C5BA5}"/>
              </a:ext>
            </a:extLst>
          </p:cNvPr>
          <p:cNvSpPr txBox="1"/>
          <p:nvPr/>
        </p:nvSpPr>
        <p:spPr>
          <a:xfrm>
            <a:off x="6267114" y="2467600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317355A1-2393-4517-906E-7F56B805E478}"/>
              </a:ext>
            </a:extLst>
          </p:cNvPr>
          <p:cNvCxnSpPr/>
          <p:nvPr/>
        </p:nvCxnSpPr>
        <p:spPr>
          <a:xfrm flipH="1">
            <a:off x="6544786" y="292773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DD2C2EE5-6D37-4DBB-AFFF-6A2A543A3872}"/>
              </a:ext>
            </a:extLst>
          </p:cNvPr>
          <p:cNvSpPr txBox="1"/>
          <p:nvPr/>
        </p:nvSpPr>
        <p:spPr>
          <a:xfrm>
            <a:off x="6273886" y="2785861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D501BD6A-9F64-41F4-93D9-5BF9306C81F8}"/>
              </a:ext>
            </a:extLst>
          </p:cNvPr>
          <p:cNvCxnSpPr/>
          <p:nvPr/>
        </p:nvCxnSpPr>
        <p:spPr>
          <a:xfrm flipH="1">
            <a:off x="6535321" y="219508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5326777A-3E65-4C7C-A2DE-2B1C40B40CF7}"/>
              </a:ext>
            </a:extLst>
          </p:cNvPr>
          <p:cNvSpPr txBox="1"/>
          <p:nvPr/>
        </p:nvSpPr>
        <p:spPr>
          <a:xfrm>
            <a:off x="6264421" y="2053210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63D32F8-56EB-4696-9EE0-628E86447BA5}"/>
              </a:ext>
            </a:extLst>
          </p:cNvPr>
          <p:cNvSpPr txBox="1"/>
          <p:nvPr/>
        </p:nvSpPr>
        <p:spPr>
          <a:xfrm>
            <a:off x="6236380" y="349219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327DD1B-245F-4FEC-AB76-3784CE0BD7FF}"/>
              </a:ext>
            </a:extLst>
          </p:cNvPr>
          <p:cNvSpPr txBox="1"/>
          <p:nvPr/>
        </p:nvSpPr>
        <p:spPr>
          <a:xfrm>
            <a:off x="501240" y="1087233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979815A5-62A6-4AB5-B020-F58609C8CB3B}"/>
              </a:ext>
            </a:extLst>
          </p:cNvPr>
          <p:cNvCxnSpPr/>
          <p:nvPr/>
        </p:nvCxnSpPr>
        <p:spPr>
          <a:xfrm flipH="1">
            <a:off x="6557260" y="1150952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2945B950-884C-4A40-A7D8-5FCEE7706980}"/>
              </a:ext>
            </a:extLst>
          </p:cNvPr>
          <p:cNvSpPr txBox="1"/>
          <p:nvPr/>
        </p:nvSpPr>
        <p:spPr>
          <a:xfrm>
            <a:off x="6286360" y="1009076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C93C49A3-C686-4E47-B702-7704066A1CC4}"/>
              </a:ext>
            </a:extLst>
          </p:cNvPr>
          <p:cNvCxnSpPr/>
          <p:nvPr/>
        </p:nvCxnSpPr>
        <p:spPr>
          <a:xfrm flipH="1">
            <a:off x="6564032" y="146921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A5555278-002C-4EA9-A9A9-894106DDE41C}"/>
              </a:ext>
            </a:extLst>
          </p:cNvPr>
          <p:cNvSpPr txBox="1"/>
          <p:nvPr/>
        </p:nvSpPr>
        <p:spPr>
          <a:xfrm>
            <a:off x="6293132" y="1327337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F1FAF554-CF59-450B-9AC6-35D64C9896FA}"/>
              </a:ext>
            </a:extLst>
          </p:cNvPr>
          <p:cNvCxnSpPr/>
          <p:nvPr/>
        </p:nvCxnSpPr>
        <p:spPr>
          <a:xfrm flipH="1">
            <a:off x="6554567" y="736562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C4A67B05-EB39-41C5-9F8C-A1A5C7A65C2C}"/>
              </a:ext>
            </a:extLst>
          </p:cNvPr>
          <p:cNvSpPr txBox="1"/>
          <p:nvPr/>
        </p:nvSpPr>
        <p:spPr>
          <a:xfrm>
            <a:off x="6283667" y="594686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46544E9F-DF91-498E-978F-18356954ED81}"/>
              </a:ext>
            </a:extLst>
          </p:cNvPr>
          <p:cNvCxnSpPr/>
          <p:nvPr/>
        </p:nvCxnSpPr>
        <p:spPr>
          <a:xfrm flipH="1">
            <a:off x="6550512" y="584808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A7B2CBF2-2C26-46C0-9B56-F44C809DFABB}"/>
              </a:ext>
            </a:extLst>
          </p:cNvPr>
          <p:cNvSpPr txBox="1"/>
          <p:nvPr/>
        </p:nvSpPr>
        <p:spPr>
          <a:xfrm>
            <a:off x="6274417" y="5706213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03E72515-FB6C-4955-92B6-C501E12709E6}"/>
              </a:ext>
            </a:extLst>
          </p:cNvPr>
          <p:cNvCxnSpPr/>
          <p:nvPr/>
        </p:nvCxnSpPr>
        <p:spPr>
          <a:xfrm flipH="1">
            <a:off x="6557284" y="6166350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94C678FF-A4A3-41DA-9231-C173042680BF}"/>
              </a:ext>
            </a:extLst>
          </p:cNvPr>
          <p:cNvSpPr txBox="1"/>
          <p:nvPr/>
        </p:nvSpPr>
        <p:spPr>
          <a:xfrm>
            <a:off x="6281189" y="6024474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64BDA76E-5862-43D4-9C59-A1C8D5746466}"/>
              </a:ext>
            </a:extLst>
          </p:cNvPr>
          <p:cNvCxnSpPr/>
          <p:nvPr/>
        </p:nvCxnSpPr>
        <p:spPr>
          <a:xfrm flipH="1">
            <a:off x="6547819" y="5376551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F452C404-8DCF-46FD-8A6B-C5389B44785F}"/>
              </a:ext>
            </a:extLst>
          </p:cNvPr>
          <p:cNvSpPr txBox="1"/>
          <p:nvPr/>
        </p:nvSpPr>
        <p:spPr>
          <a:xfrm>
            <a:off x="6271724" y="5234675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64C93347-821D-4EAF-AAC7-B6EA3FAB5BE2}"/>
              </a:ext>
            </a:extLst>
          </p:cNvPr>
          <p:cNvCxnSpPr/>
          <p:nvPr/>
        </p:nvCxnSpPr>
        <p:spPr>
          <a:xfrm flipH="1">
            <a:off x="6552502" y="431169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2A7DF23B-7F19-4E0F-AA9E-BE6F29BD8F7F}"/>
              </a:ext>
            </a:extLst>
          </p:cNvPr>
          <p:cNvSpPr txBox="1"/>
          <p:nvPr/>
        </p:nvSpPr>
        <p:spPr>
          <a:xfrm>
            <a:off x="6276407" y="4169817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D166927A-036F-4CBB-BC66-89E5A0CA653D}"/>
              </a:ext>
            </a:extLst>
          </p:cNvPr>
          <p:cNvCxnSpPr/>
          <p:nvPr/>
        </p:nvCxnSpPr>
        <p:spPr>
          <a:xfrm flipH="1">
            <a:off x="6559274" y="462995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4AA78AB3-8509-4F1F-AF58-7DE8DFCD1137}"/>
              </a:ext>
            </a:extLst>
          </p:cNvPr>
          <p:cNvSpPr txBox="1"/>
          <p:nvPr/>
        </p:nvSpPr>
        <p:spPr>
          <a:xfrm>
            <a:off x="6283179" y="448807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3AF8BADE-9367-4EA5-A0A0-4CA14DAF25E8}"/>
              </a:ext>
            </a:extLst>
          </p:cNvPr>
          <p:cNvCxnSpPr/>
          <p:nvPr/>
        </p:nvCxnSpPr>
        <p:spPr>
          <a:xfrm flipH="1">
            <a:off x="6549809" y="3840155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9105E1F0-E8AE-4E24-9B4E-5E9CA477382C}"/>
              </a:ext>
            </a:extLst>
          </p:cNvPr>
          <p:cNvSpPr txBox="1"/>
          <p:nvPr/>
        </p:nvSpPr>
        <p:spPr>
          <a:xfrm>
            <a:off x="6273714" y="369827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D09E2632-7025-4F6B-9A72-990CF639B140}"/>
              </a:ext>
            </a:extLst>
          </p:cNvPr>
          <p:cNvSpPr/>
          <p:nvPr/>
        </p:nvSpPr>
        <p:spPr>
          <a:xfrm>
            <a:off x="1155700" y="1504842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132F85C1-67EE-462D-A4C0-28BA409F761D}"/>
              </a:ext>
            </a:extLst>
          </p:cNvPr>
          <p:cNvSpPr/>
          <p:nvPr/>
        </p:nvSpPr>
        <p:spPr>
          <a:xfrm>
            <a:off x="1157532" y="2597470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2EA82654-1367-4B65-BB01-12BDBD1098EC}"/>
              </a:ext>
            </a:extLst>
          </p:cNvPr>
          <p:cNvSpPr/>
          <p:nvPr/>
        </p:nvSpPr>
        <p:spPr>
          <a:xfrm>
            <a:off x="1157532" y="4070670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C4BDF13E-4377-473C-BA4C-C14C3BEAAD03}"/>
              </a:ext>
            </a:extLst>
          </p:cNvPr>
          <p:cNvSpPr/>
          <p:nvPr/>
        </p:nvSpPr>
        <p:spPr>
          <a:xfrm>
            <a:off x="1157532" y="5239070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1331697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527AA9D-B59A-4F65-BE8C-8AB5C8BDC199}"/>
              </a:ext>
            </a:extLst>
          </p:cNvPr>
          <p:cNvSpPr txBox="1"/>
          <p:nvPr/>
        </p:nvSpPr>
        <p:spPr>
          <a:xfrm>
            <a:off x="100390" y="80339"/>
            <a:ext cx="2459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xp3.:</a:t>
            </a:r>
            <a:endParaRPr lang="en-15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E2BC999-EAA7-4287-9B59-4D66C5B69A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03" t="29960" r="6956" b="277"/>
          <a:stretch/>
        </p:blipFill>
        <p:spPr>
          <a:xfrm>
            <a:off x="991000" y="3429227"/>
            <a:ext cx="3870521" cy="152347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81AED34-D90E-4108-8FD5-561FCE13D50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8" t="19923" r="12045" b="2524"/>
          <a:stretch/>
        </p:blipFill>
        <p:spPr>
          <a:xfrm>
            <a:off x="991000" y="2419950"/>
            <a:ext cx="3780990" cy="10262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E485B0F-D6A9-4307-8D4E-97664536DF5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38" t="7827" r="1979" b="14685"/>
          <a:stretch/>
        </p:blipFill>
        <p:spPr>
          <a:xfrm>
            <a:off x="939820" y="1414473"/>
            <a:ext cx="3905871" cy="99477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2EBF616-F221-494B-80E0-97C3B0722395}"/>
              </a:ext>
            </a:extLst>
          </p:cNvPr>
          <p:cNvSpPr txBox="1"/>
          <p:nvPr/>
        </p:nvSpPr>
        <p:spPr>
          <a:xfrm>
            <a:off x="1324983" y="1135327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025BCDA-885A-41D0-80B3-6350E30FE2D7}"/>
              </a:ext>
            </a:extLst>
          </p:cNvPr>
          <p:cNvSpPr txBox="1"/>
          <p:nvPr/>
        </p:nvSpPr>
        <p:spPr>
          <a:xfrm>
            <a:off x="4487733" y="1135326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5AF5523-5FCD-4505-A799-9E7F8C15A559}"/>
              </a:ext>
            </a:extLst>
          </p:cNvPr>
          <p:cNvCxnSpPr>
            <a:cxnSpLocks/>
          </p:cNvCxnSpPr>
          <p:nvPr/>
        </p:nvCxnSpPr>
        <p:spPr>
          <a:xfrm>
            <a:off x="1443318" y="1008017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FD1AB521-E322-40CB-8375-8FBC6C3C1F36}"/>
              </a:ext>
            </a:extLst>
          </p:cNvPr>
          <p:cNvSpPr txBox="1"/>
          <p:nvPr/>
        </p:nvSpPr>
        <p:spPr>
          <a:xfrm>
            <a:off x="1681778" y="719828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E8406504-0D13-4496-A376-2DBD5C01D487}"/>
              </a:ext>
            </a:extLst>
          </p:cNvPr>
          <p:cNvCxnSpPr>
            <a:cxnSpLocks/>
          </p:cNvCxnSpPr>
          <p:nvPr/>
        </p:nvCxnSpPr>
        <p:spPr>
          <a:xfrm>
            <a:off x="2477845" y="1008449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E0F12ED9-51A1-416A-9CD2-E43DEF7754FC}"/>
              </a:ext>
            </a:extLst>
          </p:cNvPr>
          <p:cNvSpPr txBox="1"/>
          <p:nvPr/>
        </p:nvSpPr>
        <p:spPr>
          <a:xfrm>
            <a:off x="2716305" y="72026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D921ABB9-DE7E-47D5-AA0E-B5399DDD6C18}"/>
              </a:ext>
            </a:extLst>
          </p:cNvPr>
          <p:cNvCxnSpPr>
            <a:cxnSpLocks/>
          </p:cNvCxnSpPr>
          <p:nvPr/>
        </p:nvCxnSpPr>
        <p:spPr>
          <a:xfrm>
            <a:off x="3481889" y="1008017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CAF062BC-BF11-4444-A5D9-392945BDD120}"/>
              </a:ext>
            </a:extLst>
          </p:cNvPr>
          <p:cNvSpPr txBox="1"/>
          <p:nvPr/>
        </p:nvSpPr>
        <p:spPr>
          <a:xfrm>
            <a:off x="3720349" y="719828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116C47B-BDDD-4F22-9717-384DC1B2F5FF}"/>
              </a:ext>
            </a:extLst>
          </p:cNvPr>
          <p:cNvSpPr/>
          <p:nvPr/>
        </p:nvSpPr>
        <p:spPr>
          <a:xfrm>
            <a:off x="957495" y="1414472"/>
            <a:ext cx="3870521" cy="353822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9516257-C9FA-4662-B9A1-C0EAB2D484B2}"/>
              </a:ext>
            </a:extLst>
          </p:cNvPr>
          <p:cNvSpPr txBox="1"/>
          <p:nvPr/>
        </p:nvSpPr>
        <p:spPr>
          <a:xfrm>
            <a:off x="136127" y="1381671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2</a:t>
            </a:r>
            <a:endParaRPr lang="en-1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53A4A9-6392-4963-9637-54A72D9DCF5F}"/>
              </a:ext>
            </a:extLst>
          </p:cNvPr>
          <p:cNvSpPr txBox="1"/>
          <p:nvPr/>
        </p:nvSpPr>
        <p:spPr>
          <a:xfrm>
            <a:off x="4816403" y="1651550"/>
            <a:ext cx="8076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-mTOR (Ser2448)</a:t>
            </a:r>
            <a:endParaRPr lang="en-150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7B48B19-560C-4BB3-B128-526ED4E8CF08}"/>
              </a:ext>
            </a:extLst>
          </p:cNvPr>
          <p:cNvSpPr txBox="1"/>
          <p:nvPr/>
        </p:nvSpPr>
        <p:spPr>
          <a:xfrm>
            <a:off x="4823426" y="2690254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TOR</a:t>
            </a:r>
            <a:endParaRPr lang="en-150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954C09E-BE79-43E2-8AA3-74BA5A69B9FC}"/>
              </a:ext>
            </a:extLst>
          </p:cNvPr>
          <p:cNvSpPr txBox="1"/>
          <p:nvPr/>
        </p:nvSpPr>
        <p:spPr>
          <a:xfrm>
            <a:off x="4826446" y="4286312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D7641B43-CABA-45FF-B941-9AD60E888F3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" t="27444" r="9455" b="-86"/>
          <a:stretch/>
        </p:blipFill>
        <p:spPr>
          <a:xfrm>
            <a:off x="6638943" y="3995120"/>
            <a:ext cx="3655717" cy="128494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F3FA34D-E3D7-4DF3-87E4-AF733B1F722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8" t="13031" r="10172" b="71"/>
          <a:stretch/>
        </p:blipFill>
        <p:spPr>
          <a:xfrm>
            <a:off x="6570772" y="824259"/>
            <a:ext cx="3694522" cy="142602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126DB88-35C9-435F-93C8-C0BCA205DC7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6" t="21797" r="9579" b="5628"/>
          <a:stretch/>
        </p:blipFill>
        <p:spPr>
          <a:xfrm>
            <a:off x="6591890" y="5303677"/>
            <a:ext cx="3693997" cy="136019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EF485717-E0CC-4250-8058-507A300CFF1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2" t="-2653" r="10231" b="12025"/>
          <a:stretch/>
        </p:blipFill>
        <p:spPr>
          <a:xfrm>
            <a:off x="6631806" y="2232931"/>
            <a:ext cx="3642976" cy="1456583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63CBA7AC-8DE5-47C5-AF11-452B8430A7E0}"/>
              </a:ext>
            </a:extLst>
          </p:cNvPr>
          <p:cNvSpPr txBox="1"/>
          <p:nvPr/>
        </p:nvSpPr>
        <p:spPr>
          <a:xfrm>
            <a:off x="10301938" y="2904925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-EIF4E</a:t>
            </a:r>
            <a:endParaRPr lang="en-150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3F31876-7E3D-4C9D-B560-D3E058B57375}"/>
              </a:ext>
            </a:extLst>
          </p:cNvPr>
          <p:cNvSpPr txBox="1"/>
          <p:nvPr/>
        </p:nvSpPr>
        <p:spPr>
          <a:xfrm>
            <a:off x="10310914" y="5998590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IF4E</a:t>
            </a:r>
            <a:endParaRPr lang="en-150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5A38D5-E58C-404D-9026-F35F6A2F01DB}"/>
              </a:ext>
            </a:extLst>
          </p:cNvPr>
          <p:cNvSpPr txBox="1"/>
          <p:nvPr/>
        </p:nvSpPr>
        <p:spPr>
          <a:xfrm>
            <a:off x="10321855" y="1260973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925D426-05F7-4181-9B0E-E261F445F531}"/>
              </a:ext>
            </a:extLst>
          </p:cNvPr>
          <p:cNvSpPr/>
          <p:nvPr/>
        </p:nvSpPr>
        <p:spPr>
          <a:xfrm>
            <a:off x="6583190" y="813663"/>
            <a:ext cx="3691592" cy="287104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62D52B8-1F87-43FF-BB8B-AC43C20EE87C}"/>
              </a:ext>
            </a:extLst>
          </p:cNvPr>
          <p:cNvSpPr txBox="1"/>
          <p:nvPr/>
        </p:nvSpPr>
        <p:spPr>
          <a:xfrm>
            <a:off x="10310914" y="4405137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4D02573-336F-4F55-B7F0-998DF54989DC}"/>
              </a:ext>
            </a:extLst>
          </p:cNvPr>
          <p:cNvSpPr/>
          <p:nvPr/>
        </p:nvSpPr>
        <p:spPr>
          <a:xfrm>
            <a:off x="6583190" y="3961710"/>
            <a:ext cx="3691592" cy="268643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F1652EE-CEEA-433D-9900-805F603AC8FB}"/>
              </a:ext>
            </a:extLst>
          </p:cNvPr>
          <p:cNvSpPr txBox="1"/>
          <p:nvPr/>
        </p:nvSpPr>
        <p:spPr>
          <a:xfrm>
            <a:off x="5692762" y="370359"/>
            <a:ext cx="459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3</a:t>
            </a:r>
            <a:endParaRPr lang="en-15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D68306C-6F7D-4131-803A-054669C3405A}"/>
              </a:ext>
            </a:extLst>
          </p:cNvPr>
          <p:cNvSpPr txBox="1"/>
          <p:nvPr/>
        </p:nvSpPr>
        <p:spPr>
          <a:xfrm>
            <a:off x="5705119" y="3946034"/>
            <a:ext cx="459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4</a:t>
            </a:r>
            <a:endParaRPr lang="en-15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008E080-203A-4D10-AFDB-391B0FD0E624}"/>
              </a:ext>
            </a:extLst>
          </p:cNvPr>
          <p:cNvSpPr txBox="1"/>
          <p:nvPr/>
        </p:nvSpPr>
        <p:spPr>
          <a:xfrm>
            <a:off x="6974179" y="536664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FF521CE-C555-4BC8-B694-4C594DC29E98}"/>
              </a:ext>
            </a:extLst>
          </p:cNvPr>
          <p:cNvSpPr txBox="1"/>
          <p:nvPr/>
        </p:nvSpPr>
        <p:spPr>
          <a:xfrm>
            <a:off x="10136929" y="536663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20F0A5FB-5948-4416-986D-75CF5920A7B5}"/>
              </a:ext>
            </a:extLst>
          </p:cNvPr>
          <p:cNvCxnSpPr>
            <a:cxnSpLocks/>
          </p:cNvCxnSpPr>
          <p:nvPr/>
        </p:nvCxnSpPr>
        <p:spPr>
          <a:xfrm>
            <a:off x="7092514" y="409354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B269C4E4-355A-40E0-BE97-D8A392CFF3E6}"/>
              </a:ext>
            </a:extLst>
          </p:cNvPr>
          <p:cNvSpPr txBox="1"/>
          <p:nvPr/>
        </p:nvSpPr>
        <p:spPr>
          <a:xfrm>
            <a:off x="7330974" y="121165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3906D46-419E-4F32-92B4-EB168CD990CF}"/>
              </a:ext>
            </a:extLst>
          </p:cNvPr>
          <p:cNvCxnSpPr>
            <a:cxnSpLocks/>
          </p:cNvCxnSpPr>
          <p:nvPr/>
        </p:nvCxnSpPr>
        <p:spPr>
          <a:xfrm>
            <a:off x="8127041" y="409786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388A654E-3937-4719-ACEC-306C686C24CE}"/>
              </a:ext>
            </a:extLst>
          </p:cNvPr>
          <p:cNvSpPr txBox="1"/>
          <p:nvPr/>
        </p:nvSpPr>
        <p:spPr>
          <a:xfrm>
            <a:off x="8365501" y="121597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BA80C48-78E4-45A5-AB29-6FD935C2DA2B}"/>
              </a:ext>
            </a:extLst>
          </p:cNvPr>
          <p:cNvCxnSpPr>
            <a:cxnSpLocks/>
          </p:cNvCxnSpPr>
          <p:nvPr/>
        </p:nvCxnSpPr>
        <p:spPr>
          <a:xfrm>
            <a:off x="9131085" y="409354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D07AED59-4DBC-435B-8A8A-7B40E8DF0250}"/>
              </a:ext>
            </a:extLst>
          </p:cNvPr>
          <p:cNvSpPr txBox="1"/>
          <p:nvPr/>
        </p:nvSpPr>
        <p:spPr>
          <a:xfrm>
            <a:off x="9369545" y="121165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DF23BD69-2B84-401F-9BF3-23E9E6E92D1C}"/>
              </a:ext>
            </a:extLst>
          </p:cNvPr>
          <p:cNvCxnSpPr>
            <a:cxnSpLocks/>
          </p:cNvCxnSpPr>
          <p:nvPr/>
        </p:nvCxnSpPr>
        <p:spPr>
          <a:xfrm>
            <a:off x="957495" y="3410394"/>
            <a:ext cx="386895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0D2DBC87-8450-482C-8C47-3F1C731AF144}"/>
              </a:ext>
            </a:extLst>
          </p:cNvPr>
          <p:cNvCxnSpPr>
            <a:cxnSpLocks/>
          </p:cNvCxnSpPr>
          <p:nvPr/>
        </p:nvCxnSpPr>
        <p:spPr>
          <a:xfrm>
            <a:off x="957495" y="2404511"/>
            <a:ext cx="386895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64695956-D198-4D10-A264-131A96043671}"/>
              </a:ext>
            </a:extLst>
          </p:cNvPr>
          <p:cNvCxnSpPr>
            <a:cxnSpLocks/>
          </p:cNvCxnSpPr>
          <p:nvPr/>
        </p:nvCxnSpPr>
        <p:spPr>
          <a:xfrm>
            <a:off x="5086350" y="2106631"/>
            <a:ext cx="0" cy="50203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521C6E46-A05F-425E-B51E-04120DF87F94}"/>
              </a:ext>
            </a:extLst>
          </p:cNvPr>
          <p:cNvSpPr txBox="1"/>
          <p:nvPr/>
        </p:nvSpPr>
        <p:spPr>
          <a:xfrm>
            <a:off x="5066414" y="2189836"/>
            <a:ext cx="77455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mild strip</a:t>
            </a:r>
            <a:endParaRPr lang="en-150" sz="1200" dirty="0">
              <a:solidFill>
                <a:srgbClr val="FF0000"/>
              </a:solidFill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0EF75D9-4916-4372-823E-57BC4E32CF11}"/>
              </a:ext>
            </a:extLst>
          </p:cNvPr>
          <p:cNvCxnSpPr>
            <a:cxnSpLocks/>
          </p:cNvCxnSpPr>
          <p:nvPr/>
        </p:nvCxnSpPr>
        <p:spPr>
          <a:xfrm flipV="1">
            <a:off x="6597136" y="2247324"/>
            <a:ext cx="366815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55E4252E-6486-4ED8-BAA0-9D9660B45BF3}"/>
              </a:ext>
            </a:extLst>
          </p:cNvPr>
          <p:cNvCxnSpPr>
            <a:cxnSpLocks/>
          </p:cNvCxnSpPr>
          <p:nvPr/>
        </p:nvCxnSpPr>
        <p:spPr>
          <a:xfrm flipV="1">
            <a:off x="10541262" y="1567789"/>
            <a:ext cx="0" cy="124494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B901382C-CD27-4FB4-83B6-F05A69D0DDBB}"/>
              </a:ext>
            </a:extLst>
          </p:cNvPr>
          <p:cNvSpPr txBox="1"/>
          <p:nvPr/>
        </p:nvSpPr>
        <p:spPr>
          <a:xfrm>
            <a:off x="10569984" y="2125605"/>
            <a:ext cx="77455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H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r>
              <a:rPr lang="en-US" sz="1200" dirty="0">
                <a:solidFill>
                  <a:srgbClr val="FF0000"/>
                </a:solidFill>
              </a:rPr>
              <a:t>O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endParaRPr lang="en-150" sz="1200" dirty="0">
              <a:solidFill>
                <a:srgbClr val="FF0000"/>
              </a:solidFill>
            </a:endParaRP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07D8D2E2-C6F9-4595-8DC5-AABBF286638F}"/>
              </a:ext>
            </a:extLst>
          </p:cNvPr>
          <p:cNvCxnSpPr>
            <a:cxnSpLocks/>
          </p:cNvCxnSpPr>
          <p:nvPr/>
        </p:nvCxnSpPr>
        <p:spPr>
          <a:xfrm flipV="1">
            <a:off x="10540167" y="4772421"/>
            <a:ext cx="0" cy="106518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A7E5ED84-4900-41EE-A75E-95416B2383BD}"/>
              </a:ext>
            </a:extLst>
          </p:cNvPr>
          <p:cNvSpPr txBox="1"/>
          <p:nvPr/>
        </p:nvSpPr>
        <p:spPr>
          <a:xfrm>
            <a:off x="10540167" y="5183097"/>
            <a:ext cx="77455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H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r>
              <a:rPr lang="en-US" sz="1200" dirty="0">
                <a:solidFill>
                  <a:srgbClr val="FF0000"/>
                </a:solidFill>
              </a:rPr>
              <a:t>O</a:t>
            </a:r>
            <a:r>
              <a:rPr lang="en-US" sz="1200" baseline="-25000" dirty="0">
                <a:solidFill>
                  <a:srgbClr val="FF0000"/>
                </a:solidFill>
              </a:rPr>
              <a:t>2</a:t>
            </a:r>
            <a:endParaRPr lang="en-150" sz="1200" dirty="0">
              <a:solidFill>
                <a:srgbClr val="FF0000"/>
              </a:solidFill>
            </a:endParaRP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F15087F1-866D-4E40-819C-3C1A1CABCA32}"/>
              </a:ext>
            </a:extLst>
          </p:cNvPr>
          <p:cNvCxnSpPr/>
          <p:nvPr/>
        </p:nvCxnSpPr>
        <p:spPr>
          <a:xfrm flipH="1">
            <a:off x="867524" y="186304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F1471619-D2EF-4DEA-A047-B62D3E304CA8}"/>
              </a:ext>
            </a:extLst>
          </p:cNvPr>
          <p:cNvCxnSpPr/>
          <p:nvPr/>
        </p:nvCxnSpPr>
        <p:spPr>
          <a:xfrm flipH="1">
            <a:off x="871625" y="205335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DF3799E5-AE3F-460F-BCE9-474498AD5DD4}"/>
              </a:ext>
            </a:extLst>
          </p:cNvPr>
          <p:cNvSpPr txBox="1"/>
          <p:nvPr/>
        </p:nvSpPr>
        <p:spPr>
          <a:xfrm>
            <a:off x="511943" y="191702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416A6AFF-5232-483E-B51C-1A7DA252C2A4}"/>
              </a:ext>
            </a:extLst>
          </p:cNvPr>
          <p:cNvCxnSpPr/>
          <p:nvPr/>
        </p:nvCxnSpPr>
        <p:spPr>
          <a:xfrm flipH="1">
            <a:off x="871625" y="2230941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F0FA5DB3-508D-4E1B-B5A6-E32235027BF3}"/>
              </a:ext>
            </a:extLst>
          </p:cNvPr>
          <p:cNvSpPr txBox="1"/>
          <p:nvPr/>
        </p:nvSpPr>
        <p:spPr>
          <a:xfrm>
            <a:off x="511943" y="2089065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4C538D98-F9AB-4DAE-9AF9-39D3AAE4600A}"/>
              </a:ext>
            </a:extLst>
          </p:cNvPr>
          <p:cNvCxnSpPr/>
          <p:nvPr/>
        </p:nvCxnSpPr>
        <p:spPr>
          <a:xfrm flipH="1">
            <a:off x="868927" y="2358882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8AE44650-BE1F-4515-8D96-BD1FD242544A}"/>
              </a:ext>
            </a:extLst>
          </p:cNvPr>
          <p:cNvSpPr txBox="1"/>
          <p:nvPr/>
        </p:nvSpPr>
        <p:spPr>
          <a:xfrm>
            <a:off x="586943" y="2222546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E9E5188-AB85-4FCC-BE2E-61027F16BBD7}"/>
              </a:ext>
            </a:extLst>
          </p:cNvPr>
          <p:cNvSpPr txBox="1"/>
          <p:nvPr/>
        </p:nvSpPr>
        <p:spPr>
          <a:xfrm>
            <a:off x="513328" y="1720564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8341A4F1-FB64-42A4-B70F-9BDF0D1E1997}"/>
              </a:ext>
            </a:extLst>
          </p:cNvPr>
          <p:cNvCxnSpPr/>
          <p:nvPr/>
        </p:nvCxnSpPr>
        <p:spPr>
          <a:xfrm flipH="1">
            <a:off x="860122" y="286789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4E862AD6-2936-4C15-B7F9-2A623253A1A1}"/>
              </a:ext>
            </a:extLst>
          </p:cNvPr>
          <p:cNvCxnSpPr/>
          <p:nvPr/>
        </p:nvCxnSpPr>
        <p:spPr>
          <a:xfrm flipH="1">
            <a:off x="864223" y="305820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4D081ACF-B19C-4BAE-BE0E-90654853243A}"/>
              </a:ext>
            </a:extLst>
          </p:cNvPr>
          <p:cNvSpPr txBox="1"/>
          <p:nvPr/>
        </p:nvSpPr>
        <p:spPr>
          <a:xfrm>
            <a:off x="504541" y="292187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F2C4A90F-08BC-4BDF-9B7C-E805E2479B09}"/>
              </a:ext>
            </a:extLst>
          </p:cNvPr>
          <p:cNvCxnSpPr/>
          <p:nvPr/>
        </p:nvCxnSpPr>
        <p:spPr>
          <a:xfrm flipH="1">
            <a:off x="864223" y="323579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A853B3AB-0E59-49AC-AC86-9A412F0AA98E}"/>
              </a:ext>
            </a:extLst>
          </p:cNvPr>
          <p:cNvSpPr txBox="1"/>
          <p:nvPr/>
        </p:nvSpPr>
        <p:spPr>
          <a:xfrm>
            <a:off x="504541" y="3093917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106864C6-1D70-484C-A580-C82BB4C74F2A}"/>
              </a:ext>
            </a:extLst>
          </p:cNvPr>
          <p:cNvCxnSpPr/>
          <p:nvPr/>
        </p:nvCxnSpPr>
        <p:spPr>
          <a:xfrm flipH="1">
            <a:off x="861525" y="336373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675F7604-1DC9-4CFE-8E53-2B1AFBF53061}"/>
              </a:ext>
            </a:extLst>
          </p:cNvPr>
          <p:cNvSpPr txBox="1"/>
          <p:nvPr/>
        </p:nvSpPr>
        <p:spPr>
          <a:xfrm>
            <a:off x="579541" y="322739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254F721-BDF7-4C73-93AD-91812EE468D1}"/>
              </a:ext>
            </a:extLst>
          </p:cNvPr>
          <p:cNvSpPr txBox="1"/>
          <p:nvPr/>
        </p:nvSpPr>
        <p:spPr>
          <a:xfrm>
            <a:off x="505926" y="2725416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pic>
        <p:nvPicPr>
          <p:cNvPr id="82" name="Graphic 81" descr="Scissors">
            <a:extLst>
              <a:ext uri="{FF2B5EF4-FFF2-40B4-BE49-F238E27FC236}">
                <a16:creationId xmlns:a16="http://schemas.microsoft.com/office/drawing/2014/main" id="{85931141-0DB6-4D54-8529-1BD65FD40AD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 rot="2735044">
            <a:off x="4922323" y="3276798"/>
            <a:ext cx="304402" cy="304402"/>
          </a:xfrm>
          <a:prstGeom prst="rect">
            <a:avLst/>
          </a:prstGeom>
        </p:spPr>
      </p:pic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37754EB-B3EB-4091-AE2B-68D1C62D4133}"/>
              </a:ext>
            </a:extLst>
          </p:cNvPr>
          <p:cNvCxnSpPr/>
          <p:nvPr/>
        </p:nvCxnSpPr>
        <p:spPr>
          <a:xfrm flipH="1">
            <a:off x="879375" y="3552270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223DA086-3B2C-43B2-9426-80C20E569FEC}"/>
              </a:ext>
            </a:extLst>
          </p:cNvPr>
          <p:cNvSpPr txBox="1"/>
          <p:nvPr/>
        </p:nvSpPr>
        <p:spPr>
          <a:xfrm>
            <a:off x="608475" y="3410394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93FA2238-8B49-4305-AAD7-F69FA0B3ADDC}"/>
              </a:ext>
            </a:extLst>
          </p:cNvPr>
          <p:cNvCxnSpPr/>
          <p:nvPr/>
        </p:nvCxnSpPr>
        <p:spPr>
          <a:xfrm flipH="1">
            <a:off x="876049" y="4048672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C6199B49-8375-4FA2-8E45-BC31EC67F8BB}"/>
              </a:ext>
            </a:extLst>
          </p:cNvPr>
          <p:cNvSpPr txBox="1"/>
          <p:nvPr/>
        </p:nvSpPr>
        <p:spPr>
          <a:xfrm>
            <a:off x="605149" y="3857101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9ECC1F5D-BB1D-4C5F-9519-89196AE5C07C}"/>
              </a:ext>
            </a:extLst>
          </p:cNvPr>
          <p:cNvCxnSpPr/>
          <p:nvPr/>
        </p:nvCxnSpPr>
        <p:spPr>
          <a:xfrm flipH="1">
            <a:off x="889041" y="432717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28F24E5A-C3B6-49D2-B9A6-79E1CE0F9800}"/>
              </a:ext>
            </a:extLst>
          </p:cNvPr>
          <p:cNvSpPr txBox="1"/>
          <p:nvPr/>
        </p:nvSpPr>
        <p:spPr>
          <a:xfrm>
            <a:off x="618141" y="4185301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7B672C6C-D897-4818-AEBA-6A6BEA9B6861}"/>
              </a:ext>
            </a:extLst>
          </p:cNvPr>
          <p:cNvCxnSpPr/>
          <p:nvPr/>
        </p:nvCxnSpPr>
        <p:spPr>
          <a:xfrm flipH="1">
            <a:off x="6494135" y="255075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EB13AA6A-EA9C-4CA8-A8D1-144820B5FE2C}"/>
              </a:ext>
            </a:extLst>
          </p:cNvPr>
          <p:cNvSpPr txBox="1"/>
          <p:nvPr/>
        </p:nvSpPr>
        <p:spPr>
          <a:xfrm>
            <a:off x="6223235" y="2418820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8E4CB7E1-CB55-43C2-9174-CD669067737C}"/>
              </a:ext>
            </a:extLst>
          </p:cNvPr>
          <p:cNvCxnSpPr/>
          <p:nvPr/>
        </p:nvCxnSpPr>
        <p:spPr>
          <a:xfrm flipH="1">
            <a:off x="6487249" y="2998225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A6748D3D-D7CF-4A1A-A189-E470AC5BE832}"/>
              </a:ext>
            </a:extLst>
          </p:cNvPr>
          <p:cNvSpPr txBox="1"/>
          <p:nvPr/>
        </p:nvSpPr>
        <p:spPr>
          <a:xfrm>
            <a:off x="6216349" y="285634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4D9B35C-A883-4EA6-89EA-C7A0860E13AD}"/>
              </a:ext>
            </a:extLst>
          </p:cNvPr>
          <p:cNvCxnSpPr/>
          <p:nvPr/>
        </p:nvCxnSpPr>
        <p:spPr>
          <a:xfrm flipH="1">
            <a:off x="6485517" y="135229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C17B93E3-DBF5-460C-9D87-2B35347B551B}"/>
              </a:ext>
            </a:extLst>
          </p:cNvPr>
          <p:cNvSpPr txBox="1"/>
          <p:nvPr/>
        </p:nvSpPr>
        <p:spPr>
          <a:xfrm>
            <a:off x="6214617" y="1220357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37ACCEC7-4D38-42E9-AA82-28140156A0AB}"/>
              </a:ext>
            </a:extLst>
          </p:cNvPr>
          <p:cNvCxnSpPr/>
          <p:nvPr/>
        </p:nvCxnSpPr>
        <p:spPr>
          <a:xfrm flipH="1">
            <a:off x="6488570" y="1710311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CA4C331E-61A5-4437-A8C9-12F77D9BD5A4}"/>
              </a:ext>
            </a:extLst>
          </p:cNvPr>
          <p:cNvSpPr txBox="1"/>
          <p:nvPr/>
        </p:nvSpPr>
        <p:spPr>
          <a:xfrm>
            <a:off x="6217670" y="1568435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5DDB0EB-0BEB-424D-8D59-818716B83FF0}"/>
              </a:ext>
            </a:extLst>
          </p:cNvPr>
          <p:cNvSpPr txBox="1"/>
          <p:nvPr/>
        </p:nvSpPr>
        <p:spPr>
          <a:xfrm>
            <a:off x="6167401" y="52904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C373757-BD97-44C5-8D73-6BF3444EB003}"/>
              </a:ext>
            </a:extLst>
          </p:cNvPr>
          <p:cNvSpPr txBox="1"/>
          <p:nvPr/>
        </p:nvSpPr>
        <p:spPr>
          <a:xfrm>
            <a:off x="563528" y="1116606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2672FC51-7864-4EB5-A39C-4EAE44D97181}"/>
              </a:ext>
            </a:extLst>
          </p:cNvPr>
          <p:cNvCxnSpPr/>
          <p:nvPr/>
        </p:nvCxnSpPr>
        <p:spPr>
          <a:xfrm flipH="1">
            <a:off x="6497470" y="576157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D5BE47B6-5781-41C5-A083-58229C44C445}"/>
              </a:ext>
            </a:extLst>
          </p:cNvPr>
          <p:cNvSpPr txBox="1"/>
          <p:nvPr/>
        </p:nvSpPr>
        <p:spPr>
          <a:xfrm>
            <a:off x="6226570" y="5629641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EF5453C3-96B8-45B4-B672-32AB359BE88D}"/>
              </a:ext>
            </a:extLst>
          </p:cNvPr>
          <p:cNvCxnSpPr/>
          <p:nvPr/>
        </p:nvCxnSpPr>
        <p:spPr>
          <a:xfrm flipH="1">
            <a:off x="6490584" y="607983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B7798266-B01E-47B5-86EE-74CFDB2B33F0}"/>
              </a:ext>
            </a:extLst>
          </p:cNvPr>
          <p:cNvSpPr txBox="1"/>
          <p:nvPr/>
        </p:nvSpPr>
        <p:spPr>
          <a:xfrm>
            <a:off x="6219684" y="5937963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27C95F12-0385-4C5E-94BF-F3F343473A48}"/>
              </a:ext>
            </a:extLst>
          </p:cNvPr>
          <p:cNvCxnSpPr/>
          <p:nvPr/>
        </p:nvCxnSpPr>
        <p:spPr>
          <a:xfrm flipH="1">
            <a:off x="6491024" y="532159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DADBE0A9-36BC-409C-BF50-FF0E9D2585C0}"/>
              </a:ext>
            </a:extLst>
          </p:cNvPr>
          <p:cNvSpPr txBox="1"/>
          <p:nvPr/>
        </p:nvSpPr>
        <p:spPr>
          <a:xfrm>
            <a:off x="6220124" y="5189660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73E11079-BE93-4D85-A380-FAE8827062B7}"/>
              </a:ext>
            </a:extLst>
          </p:cNvPr>
          <p:cNvCxnSpPr>
            <a:cxnSpLocks/>
          </p:cNvCxnSpPr>
          <p:nvPr/>
        </p:nvCxnSpPr>
        <p:spPr>
          <a:xfrm flipV="1">
            <a:off x="6597136" y="5302170"/>
            <a:ext cx="366815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6DBAB36F-F87E-48FE-B6C5-7CCEEA35F64B}"/>
              </a:ext>
            </a:extLst>
          </p:cNvPr>
          <p:cNvCxnSpPr/>
          <p:nvPr/>
        </p:nvCxnSpPr>
        <p:spPr>
          <a:xfrm flipH="1">
            <a:off x="6500581" y="455301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27">
            <a:extLst>
              <a:ext uri="{FF2B5EF4-FFF2-40B4-BE49-F238E27FC236}">
                <a16:creationId xmlns:a16="http://schemas.microsoft.com/office/drawing/2014/main" id="{1F0ED11A-710F-43D1-961E-0337DFFB3C8C}"/>
              </a:ext>
            </a:extLst>
          </p:cNvPr>
          <p:cNvSpPr txBox="1"/>
          <p:nvPr/>
        </p:nvSpPr>
        <p:spPr>
          <a:xfrm>
            <a:off x="6229681" y="4421079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F8D489F7-5BB8-47E5-9A8D-62A487100B71}"/>
              </a:ext>
            </a:extLst>
          </p:cNvPr>
          <p:cNvCxnSpPr/>
          <p:nvPr/>
        </p:nvCxnSpPr>
        <p:spPr>
          <a:xfrm flipH="1">
            <a:off x="6493695" y="487127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BF575C14-4C7E-4AB7-AB8C-D244AA9DD031}"/>
              </a:ext>
            </a:extLst>
          </p:cNvPr>
          <p:cNvSpPr txBox="1"/>
          <p:nvPr/>
        </p:nvSpPr>
        <p:spPr>
          <a:xfrm>
            <a:off x="6222795" y="4729401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F6B33864-DCBD-458D-8E06-042A263A503C}"/>
              </a:ext>
            </a:extLst>
          </p:cNvPr>
          <p:cNvCxnSpPr/>
          <p:nvPr/>
        </p:nvCxnSpPr>
        <p:spPr>
          <a:xfrm flipH="1">
            <a:off x="6494135" y="4113035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E56AC6F5-3FB7-472B-94EE-2B6980AD2FE8}"/>
              </a:ext>
            </a:extLst>
          </p:cNvPr>
          <p:cNvSpPr txBox="1"/>
          <p:nvPr/>
        </p:nvSpPr>
        <p:spPr>
          <a:xfrm>
            <a:off x="6223235" y="3981098"/>
            <a:ext cx="388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E1B26AC3-5539-854B-888C-69A002C7B0E5}"/>
              </a:ext>
            </a:extLst>
          </p:cNvPr>
          <p:cNvSpPr/>
          <p:nvPr/>
        </p:nvSpPr>
        <p:spPr>
          <a:xfrm>
            <a:off x="6831600" y="1150943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38B81F62-E6CE-E741-9758-B0A15CDCFB0A}"/>
              </a:ext>
            </a:extLst>
          </p:cNvPr>
          <p:cNvSpPr/>
          <p:nvPr/>
        </p:nvSpPr>
        <p:spPr>
          <a:xfrm>
            <a:off x="6782826" y="2788558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70D05DCA-D285-9245-BCE6-FCC7DBA1CF05}"/>
              </a:ext>
            </a:extLst>
          </p:cNvPr>
          <p:cNvSpPr/>
          <p:nvPr/>
        </p:nvSpPr>
        <p:spPr>
          <a:xfrm>
            <a:off x="6819118" y="4324138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B2C97747-90C9-D741-8789-6DD8AC708D32}"/>
              </a:ext>
            </a:extLst>
          </p:cNvPr>
          <p:cNvSpPr/>
          <p:nvPr/>
        </p:nvSpPr>
        <p:spPr>
          <a:xfrm>
            <a:off x="6796007" y="5837603"/>
            <a:ext cx="3385872" cy="509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3796185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0EFE1E-2B76-49D3-928C-6BDF10820B81}"/>
              </a:ext>
            </a:extLst>
          </p:cNvPr>
          <p:cNvSpPr txBox="1"/>
          <p:nvPr/>
        </p:nvSpPr>
        <p:spPr>
          <a:xfrm>
            <a:off x="100390" y="80339"/>
            <a:ext cx="88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xp1.:</a:t>
            </a:r>
            <a:endParaRPr lang="en-150" dirty="0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4E6B1ECC-0EAB-4163-B358-6FBB8D3F20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"/>
          <a:stretch/>
        </p:blipFill>
        <p:spPr>
          <a:xfrm>
            <a:off x="1106582" y="1326704"/>
            <a:ext cx="3822615" cy="895846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C65DDE4-C43C-45E8-B7B0-BDB508B1D012}"/>
              </a:ext>
            </a:extLst>
          </p:cNvPr>
          <p:cNvSpPr txBox="1"/>
          <p:nvPr/>
        </p:nvSpPr>
        <p:spPr>
          <a:xfrm>
            <a:off x="1432961" y="1049705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72F29B3-0423-4F0A-B01E-588A123DF072}"/>
              </a:ext>
            </a:extLst>
          </p:cNvPr>
          <p:cNvSpPr txBox="1"/>
          <p:nvPr/>
        </p:nvSpPr>
        <p:spPr>
          <a:xfrm>
            <a:off x="4595711" y="1049704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61B1D76-1C9D-4B87-B710-F268AD8591F7}"/>
              </a:ext>
            </a:extLst>
          </p:cNvPr>
          <p:cNvCxnSpPr>
            <a:cxnSpLocks/>
          </p:cNvCxnSpPr>
          <p:nvPr/>
        </p:nvCxnSpPr>
        <p:spPr>
          <a:xfrm>
            <a:off x="1551296" y="922395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BBFBF6D-73F3-40A2-86D0-947F0E76E3AB}"/>
              </a:ext>
            </a:extLst>
          </p:cNvPr>
          <p:cNvSpPr txBox="1"/>
          <p:nvPr/>
        </p:nvSpPr>
        <p:spPr>
          <a:xfrm>
            <a:off x="1789756" y="634206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5A7ED67-DC8B-44B0-9EF4-D0CD0CF62E7C}"/>
              </a:ext>
            </a:extLst>
          </p:cNvPr>
          <p:cNvCxnSpPr>
            <a:cxnSpLocks/>
          </p:cNvCxnSpPr>
          <p:nvPr/>
        </p:nvCxnSpPr>
        <p:spPr>
          <a:xfrm>
            <a:off x="2585823" y="922827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5212189-08F4-45A8-A239-30CA1F950D3A}"/>
              </a:ext>
            </a:extLst>
          </p:cNvPr>
          <p:cNvSpPr txBox="1"/>
          <p:nvPr/>
        </p:nvSpPr>
        <p:spPr>
          <a:xfrm>
            <a:off x="2824283" y="634638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D706254-12DF-479C-AFA4-E7E7071B5EF7}"/>
              </a:ext>
            </a:extLst>
          </p:cNvPr>
          <p:cNvCxnSpPr>
            <a:cxnSpLocks/>
          </p:cNvCxnSpPr>
          <p:nvPr/>
        </p:nvCxnSpPr>
        <p:spPr>
          <a:xfrm>
            <a:off x="3589867" y="922395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742DE1D-F569-4BFE-8C4C-7E7C9BDCF94A}"/>
              </a:ext>
            </a:extLst>
          </p:cNvPr>
          <p:cNvSpPr txBox="1"/>
          <p:nvPr/>
        </p:nvSpPr>
        <p:spPr>
          <a:xfrm>
            <a:off x="3828327" y="634206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174000E-4A1B-4CEE-A7EF-05F80C1DA4D2}"/>
              </a:ext>
            </a:extLst>
          </p:cNvPr>
          <p:cNvSpPr txBox="1"/>
          <p:nvPr/>
        </p:nvSpPr>
        <p:spPr>
          <a:xfrm>
            <a:off x="4929197" y="1584717"/>
            <a:ext cx="8994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-mTOR (Ser2448)</a:t>
            </a:r>
            <a:endParaRPr lang="en-150" sz="1200" dirty="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3C6E2D6A-C50A-45D7-8BB4-0FEFD98E6EE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10929" r="2738" b="-1889"/>
          <a:stretch/>
        </p:blipFill>
        <p:spPr>
          <a:xfrm>
            <a:off x="1074767" y="3598460"/>
            <a:ext cx="3955825" cy="924881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74017B5F-C0CF-4A31-9A76-42A80C4D6456}"/>
              </a:ext>
            </a:extLst>
          </p:cNvPr>
          <p:cNvSpPr txBox="1"/>
          <p:nvPr/>
        </p:nvSpPr>
        <p:spPr>
          <a:xfrm>
            <a:off x="4983183" y="3920608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TOR</a:t>
            </a:r>
            <a:endParaRPr lang="en-150" sz="1200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8732CC26-CB95-4241-B03A-B6FE28B2110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6" t="25930" r="5427" b="23401"/>
          <a:stretch/>
        </p:blipFill>
        <p:spPr>
          <a:xfrm>
            <a:off x="1069307" y="2189698"/>
            <a:ext cx="3916566" cy="1072562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2A19A60B-49D9-4321-ADEB-DD32EE4E5D1E}"/>
              </a:ext>
            </a:extLst>
          </p:cNvPr>
          <p:cNvSpPr txBox="1"/>
          <p:nvPr/>
        </p:nvSpPr>
        <p:spPr>
          <a:xfrm>
            <a:off x="4945334" y="2838663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E8F87E99-3E3E-404B-9535-59E8B78DD78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6" t="19881" r="4214" b="17349"/>
          <a:stretch/>
        </p:blipFill>
        <p:spPr>
          <a:xfrm>
            <a:off x="1112075" y="4550272"/>
            <a:ext cx="3826257" cy="1046952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DC6287D1-E729-4B96-A763-74F309ED3BD3}"/>
              </a:ext>
            </a:extLst>
          </p:cNvPr>
          <p:cNvSpPr txBox="1"/>
          <p:nvPr/>
        </p:nvSpPr>
        <p:spPr>
          <a:xfrm>
            <a:off x="4994352" y="5008255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2217F98-3530-49A6-A264-883238C04BD4}"/>
              </a:ext>
            </a:extLst>
          </p:cNvPr>
          <p:cNvSpPr/>
          <p:nvPr/>
        </p:nvSpPr>
        <p:spPr>
          <a:xfrm>
            <a:off x="1088937" y="1326703"/>
            <a:ext cx="3872534" cy="193555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DF059430-0F19-4B73-9EAB-57B091EF0E4F}"/>
              </a:ext>
            </a:extLst>
          </p:cNvPr>
          <p:cNvSpPr/>
          <p:nvPr/>
        </p:nvSpPr>
        <p:spPr>
          <a:xfrm>
            <a:off x="1090950" y="3595741"/>
            <a:ext cx="3870521" cy="200148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89EA8F5-6D91-4917-B04C-C59D82ADB9BD}"/>
              </a:ext>
            </a:extLst>
          </p:cNvPr>
          <p:cNvSpPr txBox="1"/>
          <p:nvPr/>
        </p:nvSpPr>
        <p:spPr>
          <a:xfrm>
            <a:off x="133881" y="1361353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1</a:t>
            </a:r>
            <a:endParaRPr lang="en-15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DB16E0D-325D-4CA8-AFF4-F2C33A572978}"/>
              </a:ext>
            </a:extLst>
          </p:cNvPr>
          <p:cNvSpPr txBox="1"/>
          <p:nvPr/>
        </p:nvSpPr>
        <p:spPr>
          <a:xfrm>
            <a:off x="140391" y="3551276"/>
            <a:ext cx="709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2</a:t>
            </a:r>
            <a:endParaRPr lang="en-150" dirty="0"/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ED4194C-E0C4-4DD6-A266-84951CB4447B}"/>
              </a:ext>
            </a:extLst>
          </p:cNvPr>
          <p:cNvCxnSpPr>
            <a:cxnSpLocks/>
          </p:cNvCxnSpPr>
          <p:nvPr/>
        </p:nvCxnSpPr>
        <p:spPr>
          <a:xfrm>
            <a:off x="1088937" y="2186749"/>
            <a:ext cx="387253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4ADC389C-083E-4D6A-AB06-C20293080ABF}"/>
              </a:ext>
            </a:extLst>
          </p:cNvPr>
          <p:cNvCxnSpPr>
            <a:cxnSpLocks/>
          </p:cNvCxnSpPr>
          <p:nvPr/>
        </p:nvCxnSpPr>
        <p:spPr>
          <a:xfrm>
            <a:off x="1078965" y="4516816"/>
            <a:ext cx="387253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C0FD54F6-4243-4544-9BC7-E1565F6AF5DA}"/>
              </a:ext>
            </a:extLst>
          </p:cNvPr>
          <p:cNvSpPr txBox="1"/>
          <p:nvPr/>
        </p:nvSpPr>
        <p:spPr>
          <a:xfrm>
            <a:off x="6971155" y="1051059"/>
            <a:ext cx="34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     5    15    30    0     5    15   30   0     5     15   30</a:t>
            </a:r>
            <a:endParaRPr lang="en-150" sz="12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741DB8A-932E-47B3-B62C-96CE5F550B93}"/>
              </a:ext>
            </a:extLst>
          </p:cNvPr>
          <p:cNvSpPr txBox="1"/>
          <p:nvPr/>
        </p:nvSpPr>
        <p:spPr>
          <a:xfrm>
            <a:off x="10133905" y="1051058"/>
            <a:ext cx="925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in serum</a:t>
            </a:r>
            <a:endParaRPr lang="en-150" sz="1200" dirty="0"/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577E0CCE-FA2B-4ADD-9DE0-E4C6870B1DE9}"/>
              </a:ext>
            </a:extLst>
          </p:cNvPr>
          <p:cNvCxnSpPr>
            <a:cxnSpLocks/>
          </p:cNvCxnSpPr>
          <p:nvPr/>
        </p:nvCxnSpPr>
        <p:spPr>
          <a:xfrm>
            <a:off x="7089490" y="923749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421A208D-E22F-459D-BAD7-377BA8DF8CB0}"/>
              </a:ext>
            </a:extLst>
          </p:cNvPr>
          <p:cNvSpPr txBox="1"/>
          <p:nvPr/>
        </p:nvSpPr>
        <p:spPr>
          <a:xfrm>
            <a:off x="7327950" y="63556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38</a:t>
            </a:r>
            <a:endParaRPr lang="en-150" sz="1200" dirty="0"/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6B9326A0-E7C9-43EC-8188-B64C41D434D4}"/>
              </a:ext>
            </a:extLst>
          </p:cNvPr>
          <p:cNvCxnSpPr>
            <a:cxnSpLocks/>
          </p:cNvCxnSpPr>
          <p:nvPr/>
        </p:nvCxnSpPr>
        <p:spPr>
          <a:xfrm>
            <a:off x="8124017" y="924181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B9071D50-314A-47DC-9443-15573DD00128}"/>
              </a:ext>
            </a:extLst>
          </p:cNvPr>
          <p:cNvSpPr txBox="1"/>
          <p:nvPr/>
        </p:nvSpPr>
        <p:spPr>
          <a:xfrm>
            <a:off x="8362477" y="63599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1</a:t>
            </a:r>
            <a:endParaRPr lang="en-150" sz="1200" dirty="0"/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0EA661BA-6EA1-4986-9D4F-FE6D492F80B6}"/>
              </a:ext>
            </a:extLst>
          </p:cNvPr>
          <p:cNvCxnSpPr>
            <a:cxnSpLocks/>
          </p:cNvCxnSpPr>
          <p:nvPr/>
        </p:nvCxnSpPr>
        <p:spPr>
          <a:xfrm>
            <a:off x="9128061" y="923749"/>
            <a:ext cx="84985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16C8D278-CCA6-47CA-BEC5-20A845A13206}"/>
              </a:ext>
            </a:extLst>
          </p:cNvPr>
          <p:cNvSpPr txBox="1"/>
          <p:nvPr/>
        </p:nvSpPr>
        <p:spPr>
          <a:xfrm>
            <a:off x="9366521" y="63556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66</a:t>
            </a:r>
            <a:endParaRPr lang="en-150" sz="1200" dirty="0"/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DAD679B7-66B9-43A2-8FCC-CBC2A613802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0" t="48737" r="9352" b="-552"/>
          <a:stretch/>
        </p:blipFill>
        <p:spPr>
          <a:xfrm>
            <a:off x="6688972" y="2328383"/>
            <a:ext cx="3593215" cy="949824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84C2DE5D-E199-4B60-9CD9-11BA16524EDB}"/>
              </a:ext>
            </a:extLst>
          </p:cNvPr>
          <p:cNvSpPr txBox="1"/>
          <p:nvPr/>
        </p:nvSpPr>
        <p:spPr>
          <a:xfrm>
            <a:off x="10264990" y="2405284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-EIF4E</a:t>
            </a:r>
            <a:endParaRPr lang="en-150" sz="1200" dirty="0"/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A5B6C35A-C1FB-4FD0-9520-43FC6C2DE85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5" t="47576" r="10789" b="2616"/>
          <a:stretch/>
        </p:blipFill>
        <p:spPr>
          <a:xfrm>
            <a:off x="6674899" y="4754998"/>
            <a:ext cx="3619599" cy="869735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D8223E4A-65C8-4DBD-91E8-3BDAD3E95BE5}"/>
              </a:ext>
            </a:extLst>
          </p:cNvPr>
          <p:cNvSpPr txBox="1"/>
          <p:nvPr/>
        </p:nvSpPr>
        <p:spPr>
          <a:xfrm>
            <a:off x="10264989" y="4864494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IF4E</a:t>
            </a:r>
            <a:endParaRPr lang="en-150" sz="1200" dirty="0"/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C76C325D-6F2C-48DE-8F40-1F3566E4F95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4" t="-1894" r="6011" b="30809"/>
          <a:stretch/>
        </p:blipFill>
        <p:spPr>
          <a:xfrm>
            <a:off x="6725937" y="1333719"/>
            <a:ext cx="3568563" cy="986780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2783C5DE-F778-4FB6-AD4D-408D3E044BDF}"/>
              </a:ext>
            </a:extLst>
          </p:cNvPr>
          <p:cNvSpPr txBox="1"/>
          <p:nvPr/>
        </p:nvSpPr>
        <p:spPr>
          <a:xfrm>
            <a:off x="10229557" y="2034025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24CCD222-90FB-4A1A-A3FF-67C8C91B6171}"/>
              </a:ext>
            </a:extLst>
          </p:cNvPr>
          <p:cNvSpPr/>
          <p:nvPr/>
        </p:nvSpPr>
        <p:spPr>
          <a:xfrm>
            <a:off x="6696429" y="1344173"/>
            <a:ext cx="3568563" cy="193182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B567620-7E11-42AC-A443-581AB392B6FC}"/>
              </a:ext>
            </a:extLst>
          </p:cNvPr>
          <p:cNvSpPr txBox="1"/>
          <p:nvPr/>
        </p:nvSpPr>
        <p:spPr>
          <a:xfrm>
            <a:off x="5820421" y="956164"/>
            <a:ext cx="490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3</a:t>
            </a:r>
            <a:endParaRPr lang="en-150" dirty="0"/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19B5BA9D-998F-424B-9D31-93EC83599A7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1" t="-710" r="10535" b="25568"/>
          <a:stretch/>
        </p:blipFill>
        <p:spPr>
          <a:xfrm>
            <a:off x="6686606" y="3627704"/>
            <a:ext cx="3578385" cy="1105701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DB3D6D69-9C90-46C0-AAE1-4C3172B1B559}"/>
              </a:ext>
            </a:extLst>
          </p:cNvPr>
          <p:cNvSpPr txBox="1"/>
          <p:nvPr/>
        </p:nvSpPr>
        <p:spPr>
          <a:xfrm>
            <a:off x="10264990" y="4307347"/>
            <a:ext cx="77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  <a:endParaRPr lang="en-150" sz="1200" dirty="0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16C35DB5-0B68-4155-BBF8-D3BEF6F2ED6A}"/>
              </a:ext>
            </a:extLst>
          </p:cNvPr>
          <p:cNvSpPr/>
          <p:nvPr/>
        </p:nvSpPr>
        <p:spPr>
          <a:xfrm>
            <a:off x="6696429" y="3613833"/>
            <a:ext cx="3568563" cy="19928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15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35A0A5C-A84D-41C7-964E-BFFA0728E175}"/>
              </a:ext>
            </a:extLst>
          </p:cNvPr>
          <p:cNvSpPr txBox="1"/>
          <p:nvPr/>
        </p:nvSpPr>
        <p:spPr>
          <a:xfrm>
            <a:off x="5787278" y="3672057"/>
            <a:ext cx="439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4</a:t>
            </a:r>
            <a:endParaRPr lang="en-150" dirty="0"/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D42CD76B-2398-42F4-8EFA-F57967140F55}"/>
              </a:ext>
            </a:extLst>
          </p:cNvPr>
          <p:cNvCxnSpPr>
            <a:cxnSpLocks/>
          </p:cNvCxnSpPr>
          <p:nvPr/>
        </p:nvCxnSpPr>
        <p:spPr>
          <a:xfrm>
            <a:off x="6702295" y="2334623"/>
            <a:ext cx="35798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39D73EA8-7176-49BE-B9D5-09BD657842FD}"/>
              </a:ext>
            </a:extLst>
          </p:cNvPr>
          <p:cNvCxnSpPr>
            <a:cxnSpLocks/>
          </p:cNvCxnSpPr>
          <p:nvPr/>
        </p:nvCxnSpPr>
        <p:spPr>
          <a:xfrm>
            <a:off x="6688972" y="4729917"/>
            <a:ext cx="35798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1E3B8B64-7BC5-4AE2-B162-375F85E91A72}"/>
              </a:ext>
            </a:extLst>
          </p:cNvPr>
          <p:cNvCxnSpPr/>
          <p:nvPr/>
        </p:nvCxnSpPr>
        <p:spPr>
          <a:xfrm flipH="1">
            <a:off x="1000900" y="177462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41DD1384-5EF6-4EA6-8F34-619FE71E51BF}"/>
              </a:ext>
            </a:extLst>
          </p:cNvPr>
          <p:cNvSpPr txBox="1"/>
          <p:nvPr/>
        </p:nvSpPr>
        <p:spPr>
          <a:xfrm>
            <a:off x="646760" y="1632751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FAB1244-894C-4EA5-A491-8F03E169E216}"/>
              </a:ext>
            </a:extLst>
          </p:cNvPr>
          <p:cNvSpPr txBox="1"/>
          <p:nvPr/>
        </p:nvSpPr>
        <p:spPr>
          <a:xfrm>
            <a:off x="674580" y="1069830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98DD597C-2075-4492-8EA5-688A8C83F8DA}"/>
              </a:ext>
            </a:extLst>
          </p:cNvPr>
          <p:cNvCxnSpPr/>
          <p:nvPr/>
        </p:nvCxnSpPr>
        <p:spPr>
          <a:xfrm flipH="1">
            <a:off x="1005001" y="2108864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7B9DA0D6-3B75-4804-B63C-9A4FA9F89FF8}"/>
              </a:ext>
            </a:extLst>
          </p:cNvPr>
          <p:cNvSpPr txBox="1"/>
          <p:nvPr/>
        </p:nvSpPr>
        <p:spPr>
          <a:xfrm>
            <a:off x="650861" y="1966988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B777ECE4-BF08-43C1-A538-D7BAFAD85F84}"/>
              </a:ext>
            </a:extLst>
          </p:cNvPr>
          <p:cNvCxnSpPr/>
          <p:nvPr/>
        </p:nvCxnSpPr>
        <p:spPr>
          <a:xfrm flipH="1">
            <a:off x="1006817" y="234407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78B8C946-297E-43AE-A256-9C0C94F47213}"/>
              </a:ext>
            </a:extLst>
          </p:cNvPr>
          <p:cNvSpPr txBox="1"/>
          <p:nvPr/>
        </p:nvSpPr>
        <p:spPr>
          <a:xfrm>
            <a:off x="723125" y="2202202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F4C282D6-7A58-4279-B149-A8555638A324}"/>
              </a:ext>
            </a:extLst>
          </p:cNvPr>
          <p:cNvCxnSpPr/>
          <p:nvPr/>
        </p:nvCxnSpPr>
        <p:spPr>
          <a:xfrm flipH="1">
            <a:off x="1010801" y="292734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5A04CF0C-585B-43BC-9B09-97ADD17E4C69}"/>
              </a:ext>
            </a:extLst>
          </p:cNvPr>
          <p:cNvSpPr txBox="1"/>
          <p:nvPr/>
        </p:nvSpPr>
        <p:spPr>
          <a:xfrm>
            <a:off x="727109" y="2785471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A2103473-9AAB-42FA-B689-4CB5E7A298C7}"/>
              </a:ext>
            </a:extLst>
          </p:cNvPr>
          <p:cNvCxnSpPr/>
          <p:nvPr/>
        </p:nvCxnSpPr>
        <p:spPr>
          <a:xfrm flipH="1">
            <a:off x="1005001" y="412807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DE1EB2B4-8777-4CE8-A94D-29E9C7872508}"/>
              </a:ext>
            </a:extLst>
          </p:cNvPr>
          <p:cNvSpPr txBox="1"/>
          <p:nvPr/>
        </p:nvSpPr>
        <p:spPr>
          <a:xfrm>
            <a:off x="650861" y="398620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0</a:t>
            </a:r>
            <a:endParaRPr lang="en-150" sz="1200" dirty="0"/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9456A174-584F-4E2B-9FF3-CE6E811A622F}"/>
              </a:ext>
            </a:extLst>
          </p:cNvPr>
          <p:cNvCxnSpPr/>
          <p:nvPr/>
        </p:nvCxnSpPr>
        <p:spPr>
          <a:xfrm flipH="1">
            <a:off x="1009102" y="4462315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4FC5F85E-CAB1-460E-A7CD-30A7270A5739}"/>
              </a:ext>
            </a:extLst>
          </p:cNvPr>
          <p:cNvSpPr txBox="1"/>
          <p:nvPr/>
        </p:nvSpPr>
        <p:spPr>
          <a:xfrm>
            <a:off x="654962" y="4320439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C561B322-20C4-41A0-AF84-0DFBC9086279}"/>
              </a:ext>
            </a:extLst>
          </p:cNvPr>
          <p:cNvCxnSpPr/>
          <p:nvPr/>
        </p:nvCxnSpPr>
        <p:spPr>
          <a:xfrm flipH="1">
            <a:off x="1003166" y="460597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817E1C88-6E96-4F1C-8F9E-D89D91889A16}"/>
              </a:ext>
            </a:extLst>
          </p:cNvPr>
          <p:cNvSpPr txBox="1"/>
          <p:nvPr/>
        </p:nvSpPr>
        <p:spPr>
          <a:xfrm>
            <a:off x="719474" y="4464101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79853DCC-5954-469E-997D-108F999C8D55}"/>
              </a:ext>
            </a:extLst>
          </p:cNvPr>
          <p:cNvCxnSpPr/>
          <p:nvPr/>
        </p:nvCxnSpPr>
        <p:spPr>
          <a:xfrm flipH="1">
            <a:off x="1007150" y="5196620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B6F26300-AE93-4705-818A-9B117A3B1295}"/>
              </a:ext>
            </a:extLst>
          </p:cNvPr>
          <p:cNvSpPr txBox="1"/>
          <p:nvPr/>
        </p:nvSpPr>
        <p:spPr>
          <a:xfrm>
            <a:off x="723458" y="5054744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9CA5638E-28C9-45E0-8816-F7F615E16194}"/>
              </a:ext>
            </a:extLst>
          </p:cNvPr>
          <p:cNvCxnSpPr/>
          <p:nvPr/>
        </p:nvCxnSpPr>
        <p:spPr>
          <a:xfrm flipH="1">
            <a:off x="6628280" y="246320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A6DF5B2C-6B38-4515-BB35-5B62C52DF2FD}"/>
              </a:ext>
            </a:extLst>
          </p:cNvPr>
          <p:cNvSpPr txBox="1"/>
          <p:nvPr/>
        </p:nvSpPr>
        <p:spPr>
          <a:xfrm>
            <a:off x="6344588" y="2321332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995C1FED-31CB-42BC-8170-085D087845CA}"/>
              </a:ext>
            </a:extLst>
          </p:cNvPr>
          <p:cNvCxnSpPr/>
          <p:nvPr/>
        </p:nvCxnSpPr>
        <p:spPr>
          <a:xfrm flipH="1">
            <a:off x="6632264" y="306657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51A87142-7104-4E57-ABB4-4111E6BB247D}"/>
              </a:ext>
            </a:extLst>
          </p:cNvPr>
          <p:cNvSpPr txBox="1"/>
          <p:nvPr/>
        </p:nvSpPr>
        <p:spPr>
          <a:xfrm>
            <a:off x="6348572" y="2924697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5</a:t>
            </a:r>
            <a:endParaRPr lang="en-150" sz="1200" dirty="0"/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7A1C93D8-A9D8-4C46-9F1C-506FCFDCE950}"/>
              </a:ext>
            </a:extLst>
          </p:cNvPr>
          <p:cNvCxnSpPr/>
          <p:nvPr/>
        </p:nvCxnSpPr>
        <p:spPr>
          <a:xfrm flipH="1">
            <a:off x="6622427" y="213105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CA97FAE6-E561-415F-8691-748550F581CE}"/>
              </a:ext>
            </a:extLst>
          </p:cNvPr>
          <p:cNvSpPr txBox="1"/>
          <p:nvPr/>
        </p:nvSpPr>
        <p:spPr>
          <a:xfrm>
            <a:off x="6338735" y="1989177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8E234EE4-FD54-47FE-85EC-14C828E34B1E}"/>
              </a:ext>
            </a:extLst>
          </p:cNvPr>
          <p:cNvCxnSpPr/>
          <p:nvPr/>
        </p:nvCxnSpPr>
        <p:spPr>
          <a:xfrm flipH="1">
            <a:off x="6613814" y="180198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985E4880-0B4A-48AB-9AB8-0A4EF2FA23E4}"/>
              </a:ext>
            </a:extLst>
          </p:cNvPr>
          <p:cNvSpPr txBox="1"/>
          <p:nvPr/>
        </p:nvSpPr>
        <p:spPr>
          <a:xfrm>
            <a:off x="6330122" y="1660112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D3E95307-4428-46D1-B8DA-913B63179774}"/>
              </a:ext>
            </a:extLst>
          </p:cNvPr>
          <p:cNvCxnSpPr/>
          <p:nvPr/>
        </p:nvCxnSpPr>
        <p:spPr>
          <a:xfrm flipH="1">
            <a:off x="6615863" y="164371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BED2EEF7-50D9-447C-A527-94D343BD1011}"/>
              </a:ext>
            </a:extLst>
          </p:cNvPr>
          <p:cNvSpPr txBox="1"/>
          <p:nvPr/>
        </p:nvSpPr>
        <p:spPr>
          <a:xfrm>
            <a:off x="6332171" y="1501842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3A895FED-26EA-4FAF-ABDA-E8FB19327508}"/>
              </a:ext>
            </a:extLst>
          </p:cNvPr>
          <p:cNvCxnSpPr/>
          <p:nvPr/>
        </p:nvCxnSpPr>
        <p:spPr>
          <a:xfrm flipH="1">
            <a:off x="6617814" y="153544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9630304F-86CF-44E9-89DA-9E3D033C6C67}"/>
              </a:ext>
            </a:extLst>
          </p:cNvPr>
          <p:cNvSpPr txBox="1"/>
          <p:nvPr/>
        </p:nvSpPr>
        <p:spPr>
          <a:xfrm>
            <a:off x="6250160" y="1393567"/>
            <a:ext cx="444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61CA2560-0ACF-49B5-A3CC-17A7E4F106F4}"/>
              </a:ext>
            </a:extLst>
          </p:cNvPr>
          <p:cNvCxnSpPr/>
          <p:nvPr/>
        </p:nvCxnSpPr>
        <p:spPr>
          <a:xfrm flipH="1">
            <a:off x="6612379" y="1399300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2A5B70F3-FA7B-4FB5-B272-D7C9D1BDC486}"/>
              </a:ext>
            </a:extLst>
          </p:cNvPr>
          <p:cNvSpPr txBox="1"/>
          <p:nvPr/>
        </p:nvSpPr>
        <p:spPr>
          <a:xfrm>
            <a:off x="6254987" y="1257424"/>
            <a:ext cx="464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30</a:t>
            </a:r>
            <a:endParaRPr lang="en-150" sz="1200" dirty="0"/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9B625248-6F48-45C9-BE2D-FE273F1C0244}"/>
              </a:ext>
            </a:extLst>
          </p:cNvPr>
          <p:cNvCxnSpPr/>
          <p:nvPr/>
        </p:nvCxnSpPr>
        <p:spPr>
          <a:xfrm flipH="1">
            <a:off x="6604978" y="4905569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4D010C02-D97A-47C0-988E-E635D4B1554A}"/>
              </a:ext>
            </a:extLst>
          </p:cNvPr>
          <p:cNvSpPr txBox="1"/>
          <p:nvPr/>
        </p:nvSpPr>
        <p:spPr>
          <a:xfrm>
            <a:off x="6321286" y="4763693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5</a:t>
            </a:r>
            <a:endParaRPr lang="en-150" sz="1200" dirty="0"/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B053B51A-EE4E-488A-86CF-4E1AF5BA84D8}"/>
              </a:ext>
            </a:extLst>
          </p:cNvPr>
          <p:cNvCxnSpPr/>
          <p:nvPr/>
        </p:nvCxnSpPr>
        <p:spPr>
          <a:xfrm flipH="1">
            <a:off x="6604978" y="5529540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BCC4FBF9-6FF5-46FD-9824-339F48901D60}"/>
              </a:ext>
            </a:extLst>
          </p:cNvPr>
          <p:cNvSpPr txBox="1"/>
          <p:nvPr/>
        </p:nvSpPr>
        <p:spPr>
          <a:xfrm>
            <a:off x="6321286" y="5387664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5</a:t>
            </a:r>
            <a:endParaRPr lang="en-150" sz="1200" dirty="0"/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A1D4BE33-88AB-4051-A8D7-EC15F2199D40}"/>
              </a:ext>
            </a:extLst>
          </p:cNvPr>
          <p:cNvCxnSpPr/>
          <p:nvPr/>
        </p:nvCxnSpPr>
        <p:spPr>
          <a:xfrm flipH="1">
            <a:off x="6602319" y="4425633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57698400-3C03-481A-A03D-26F1CDB8DE73}"/>
              </a:ext>
            </a:extLst>
          </p:cNvPr>
          <p:cNvSpPr txBox="1"/>
          <p:nvPr/>
        </p:nvSpPr>
        <p:spPr>
          <a:xfrm>
            <a:off x="6318627" y="4283757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5</a:t>
            </a:r>
            <a:endParaRPr lang="en-150" sz="1200" dirty="0"/>
          </a:p>
        </p:txBody>
      </p: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816E4DA5-661A-40C4-8F1B-CA7B97991F3D}"/>
              </a:ext>
            </a:extLst>
          </p:cNvPr>
          <p:cNvCxnSpPr/>
          <p:nvPr/>
        </p:nvCxnSpPr>
        <p:spPr>
          <a:xfrm flipH="1">
            <a:off x="6603182" y="4072878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379B2497-2DC8-4709-B8B1-16CD1671D942}"/>
              </a:ext>
            </a:extLst>
          </p:cNvPr>
          <p:cNvSpPr txBox="1"/>
          <p:nvPr/>
        </p:nvSpPr>
        <p:spPr>
          <a:xfrm>
            <a:off x="6319489" y="3935740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5</a:t>
            </a:r>
            <a:endParaRPr lang="en-150" sz="1200" dirty="0"/>
          </a:p>
        </p:txBody>
      </p: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89A5A7AB-9125-444C-9B6E-C5B963B0F543}"/>
              </a:ext>
            </a:extLst>
          </p:cNvPr>
          <p:cNvCxnSpPr/>
          <p:nvPr/>
        </p:nvCxnSpPr>
        <p:spPr>
          <a:xfrm flipH="1">
            <a:off x="6600493" y="3895656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id="{17A54BFB-817E-4B65-86F0-6F2B7FE5AE07}"/>
              </a:ext>
            </a:extLst>
          </p:cNvPr>
          <p:cNvSpPr txBox="1"/>
          <p:nvPr/>
        </p:nvSpPr>
        <p:spPr>
          <a:xfrm>
            <a:off x="6313655" y="3764327"/>
            <a:ext cx="401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0</a:t>
            </a:r>
            <a:endParaRPr lang="en-150" sz="1200" dirty="0"/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AC3A02BE-496D-44DF-8BD6-A8C6C761FC98}"/>
              </a:ext>
            </a:extLst>
          </p:cNvPr>
          <p:cNvCxnSpPr/>
          <p:nvPr/>
        </p:nvCxnSpPr>
        <p:spPr>
          <a:xfrm flipH="1">
            <a:off x="6602444" y="3763697"/>
            <a:ext cx="79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41">
            <a:extLst>
              <a:ext uri="{FF2B5EF4-FFF2-40B4-BE49-F238E27FC236}">
                <a16:creationId xmlns:a16="http://schemas.microsoft.com/office/drawing/2014/main" id="{2483A966-492D-408F-8564-1DB55E22AD7F}"/>
              </a:ext>
            </a:extLst>
          </p:cNvPr>
          <p:cNvSpPr txBox="1"/>
          <p:nvPr/>
        </p:nvSpPr>
        <p:spPr>
          <a:xfrm>
            <a:off x="6237871" y="3624383"/>
            <a:ext cx="444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</a:t>
            </a:r>
            <a:endParaRPr lang="en-150" sz="1200" dirty="0"/>
          </a:p>
        </p:txBody>
      </p:sp>
      <p:pic>
        <p:nvPicPr>
          <p:cNvPr id="146" name="Graphic 145" descr="Scissors">
            <a:extLst>
              <a:ext uri="{FF2B5EF4-FFF2-40B4-BE49-F238E27FC236}">
                <a16:creationId xmlns:a16="http://schemas.microsoft.com/office/drawing/2014/main" id="{3C3802BE-7951-40AE-83D5-53C200B7DEA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 rot="2735044">
            <a:off x="5066231" y="2038701"/>
            <a:ext cx="304402" cy="304402"/>
          </a:xfrm>
          <a:prstGeom prst="rect">
            <a:avLst/>
          </a:prstGeom>
        </p:spPr>
      </p:pic>
      <p:pic>
        <p:nvPicPr>
          <p:cNvPr id="147" name="Graphic 146" descr="Scissors">
            <a:extLst>
              <a:ext uri="{FF2B5EF4-FFF2-40B4-BE49-F238E27FC236}">
                <a16:creationId xmlns:a16="http://schemas.microsoft.com/office/drawing/2014/main" id="{A533FD64-FD3C-4EE0-90C0-7E621DEDEC6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 rot="2735044">
            <a:off x="5056951" y="4376696"/>
            <a:ext cx="304402" cy="304402"/>
          </a:xfrm>
          <a:prstGeom prst="rect">
            <a:avLst/>
          </a:prstGeom>
        </p:spPr>
      </p:pic>
      <p:pic>
        <p:nvPicPr>
          <p:cNvPr id="148" name="Graphic 147" descr="Scissors">
            <a:extLst>
              <a:ext uri="{FF2B5EF4-FFF2-40B4-BE49-F238E27FC236}">
                <a16:creationId xmlns:a16="http://schemas.microsoft.com/office/drawing/2014/main" id="{E6191C35-D39F-48B3-9094-9C1562FD65C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 rot="2735044">
            <a:off x="10336254" y="2182421"/>
            <a:ext cx="304402" cy="304402"/>
          </a:xfrm>
          <a:prstGeom prst="rect">
            <a:avLst/>
          </a:prstGeom>
        </p:spPr>
      </p:pic>
      <p:pic>
        <p:nvPicPr>
          <p:cNvPr id="149" name="Graphic 148" descr="Scissors">
            <a:extLst>
              <a:ext uri="{FF2B5EF4-FFF2-40B4-BE49-F238E27FC236}">
                <a16:creationId xmlns:a16="http://schemas.microsoft.com/office/drawing/2014/main" id="{AD3430B3-8A7A-4BA4-8DD3-1A3686F5615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 rot="2735044">
            <a:off x="10349554" y="4572219"/>
            <a:ext cx="304402" cy="304402"/>
          </a:xfrm>
          <a:prstGeom prst="rect">
            <a:avLst/>
          </a:prstGeom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A580E8CE-6E54-4B0C-9220-1B9BE23D468D}"/>
              </a:ext>
            </a:extLst>
          </p:cNvPr>
          <p:cNvSpPr txBox="1"/>
          <p:nvPr/>
        </p:nvSpPr>
        <p:spPr>
          <a:xfrm>
            <a:off x="6271563" y="1037292"/>
            <a:ext cx="471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kDa</a:t>
            </a:r>
            <a:endParaRPr lang="en-150" sz="1200" dirty="0"/>
          </a:p>
        </p:txBody>
      </p:sp>
    </p:spTree>
    <p:extLst>
      <p:ext uri="{BB962C8B-B14F-4D97-AF65-F5344CB8AC3E}">
        <p14:creationId xmlns:p14="http://schemas.microsoft.com/office/powerpoint/2010/main" val="3546185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72</Words>
  <Application>Microsoft Macintosh PowerPoint</Application>
  <PresentationFormat>Grand écran</PresentationFormat>
  <Paragraphs>172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glarka ZAMBO</dc:creator>
  <cp:lastModifiedBy>Herve MOINE</cp:lastModifiedBy>
  <cp:revision>4</cp:revision>
  <dcterms:created xsi:type="dcterms:W3CDTF">2021-12-09T14:08:19Z</dcterms:created>
  <dcterms:modified xsi:type="dcterms:W3CDTF">2021-12-13T14:49:06Z</dcterms:modified>
</cp:coreProperties>
</file>